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0" r:id="rId3"/>
  </p:sldIdLst>
  <p:sldSz cx="6858000" cy="12192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004" y="-3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995508"/>
            <a:ext cx="5143500" cy="42450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6404254"/>
            <a:ext cx="5143500" cy="29438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649175"/>
            <a:ext cx="1478756" cy="1033317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649175"/>
            <a:ext cx="4350544" cy="1033317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3039834"/>
            <a:ext cx="5915025" cy="50720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8159849"/>
            <a:ext cx="5915025" cy="2667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49175"/>
            <a:ext cx="5915025" cy="2356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989029"/>
            <a:ext cx="2901255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4453905"/>
            <a:ext cx="2901255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989029"/>
            <a:ext cx="2915543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4453905"/>
            <a:ext cx="2915543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649175"/>
            <a:ext cx="5915025" cy="2356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3245875"/>
            <a:ext cx="5915025" cy="7736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8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11301291"/>
            <a:ext cx="2314575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1" name="组合 220"/>
          <p:cNvGrpSpPr/>
          <p:nvPr/>
        </p:nvGrpSpPr>
        <p:grpSpPr>
          <a:xfrm>
            <a:off x="-33020" y="484505"/>
            <a:ext cx="7119620" cy="9462135"/>
            <a:chOff x="-52" y="763"/>
            <a:chExt cx="11212" cy="14901"/>
          </a:xfrm>
        </p:grpSpPr>
        <p:grpSp>
          <p:nvGrpSpPr>
            <p:cNvPr id="211" name="组合 210"/>
            <p:cNvGrpSpPr/>
            <p:nvPr/>
          </p:nvGrpSpPr>
          <p:grpSpPr>
            <a:xfrm>
              <a:off x="336" y="1447"/>
              <a:ext cx="4560" cy="2065"/>
              <a:chOff x="336" y="-85"/>
              <a:chExt cx="4560" cy="3885"/>
            </a:xfrm>
          </p:grpSpPr>
          <p:sp>
            <p:nvSpPr>
              <p:cNvPr id="2" name="Freeform 25"/>
              <p:cNvSpPr>
                <a:spLocks noEditPoints="1"/>
              </p:cNvSpPr>
              <p:nvPr/>
            </p:nvSpPr>
            <p:spPr bwMode="auto">
              <a:xfrm>
                <a:off x="659" y="-16"/>
                <a:ext cx="4231" cy="3531"/>
              </a:xfrm>
              <a:custGeom>
                <a:avLst/>
                <a:gdLst>
                  <a:gd name="T0" fmla="*/ 0 w 1217"/>
                  <a:gd name="T1" fmla="*/ 1127 h 1130"/>
                  <a:gd name="T2" fmla="*/ 1217 w 1217"/>
                  <a:gd name="T3" fmla="*/ 1127 h 1130"/>
                  <a:gd name="T4" fmla="*/ 1217 w 1217"/>
                  <a:gd name="T5" fmla="*/ 1130 h 1130"/>
                  <a:gd name="T6" fmla="*/ 0 w 1217"/>
                  <a:gd name="T7" fmla="*/ 1130 h 1130"/>
                  <a:gd name="T8" fmla="*/ 0 w 1217"/>
                  <a:gd name="T9" fmla="*/ 1127 h 1130"/>
                  <a:gd name="T10" fmla="*/ 0 w 1217"/>
                  <a:gd name="T11" fmla="*/ 1014 h 1130"/>
                  <a:gd name="T12" fmla="*/ 1217 w 1217"/>
                  <a:gd name="T13" fmla="*/ 1014 h 1130"/>
                  <a:gd name="T14" fmla="*/ 1217 w 1217"/>
                  <a:gd name="T15" fmla="*/ 1017 h 1130"/>
                  <a:gd name="T16" fmla="*/ 0 w 1217"/>
                  <a:gd name="T17" fmla="*/ 1017 h 1130"/>
                  <a:gd name="T18" fmla="*/ 0 w 1217"/>
                  <a:gd name="T19" fmla="*/ 1014 h 1130"/>
                  <a:gd name="T20" fmla="*/ 0 w 1217"/>
                  <a:gd name="T21" fmla="*/ 902 h 1130"/>
                  <a:gd name="T22" fmla="*/ 1217 w 1217"/>
                  <a:gd name="T23" fmla="*/ 902 h 1130"/>
                  <a:gd name="T24" fmla="*/ 1217 w 1217"/>
                  <a:gd name="T25" fmla="*/ 905 h 1130"/>
                  <a:gd name="T26" fmla="*/ 0 w 1217"/>
                  <a:gd name="T27" fmla="*/ 905 h 1130"/>
                  <a:gd name="T28" fmla="*/ 0 w 1217"/>
                  <a:gd name="T29" fmla="*/ 902 h 1130"/>
                  <a:gd name="T30" fmla="*/ 0 w 1217"/>
                  <a:gd name="T31" fmla="*/ 789 h 1130"/>
                  <a:gd name="T32" fmla="*/ 1217 w 1217"/>
                  <a:gd name="T33" fmla="*/ 789 h 1130"/>
                  <a:gd name="T34" fmla="*/ 1217 w 1217"/>
                  <a:gd name="T35" fmla="*/ 792 h 1130"/>
                  <a:gd name="T36" fmla="*/ 0 w 1217"/>
                  <a:gd name="T37" fmla="*/ 792 h 1130"/>
                  <a:gd name="T38" fmla="*/ 0 w 1217"/>
                  <a:gd name="T39" fmla="*/ 789 h 1130"/>
                  <a:gd name="T40" fmla="*/ 0 w 1217"/>
                  <a:gd name="T41" fmla="*/ 676 h 1130"/>
                  <a:gd name="T42" fmla="*/ 1217 w 1217"/>
                  <a:gd name="T43" fmla="*/ 676 h 1130"/>
                  <a:gd name="T44" fmla="*/ 1217 w 1217"/>
                  <a:gd name="T45" fmla="*/ 679 h 1130"/>
                  <a:gd name="T46" fmla="*/ 0 w 1217"/>
                  <a:gd name="T47" fmla="*/ 679 h 1130"/>
                  <a:gd name="T48" fmla="*/ 0 w 1217"/>
                  <a:gd name="T49" fmla="*/ 676 h 1130"/>
                  <a:gd name="T50" fmla="*/ 0 w 1217"/>
                  <a:gd name="T51" fmla="*/ 564 h 1130"/>
                  <a:gd name="T52" fmla="*/ 1217 w 1217"/>
                  <a:gd name="T53" fmla="*/ 564 h 1130"/>
                  <a:gd name="T54" fmla="*/ 1217 w 1217"/>
                  <a:gd name="T55" fmla="*/ 566 h 1130"/>
                  <a:gd name="T56" fmla="*/ 0 w 1217"/>
                  <a:gd name="T57" fmla="*/ 566 h 1130"/>
                  <a:gd name="T58" fmla="*/ 0 w 1217"/>
                  <a:gd name="T59" fmla="*/ 564 h 1130"/>
                  <a:gd name="T60" fmla="*/ 0 w 1217"/>
                  <a:gd name="T61" fmla="*/ 451 h 1130"/>
                  <a:gd name="T62" fmla="*/ 1217 w 1217"/>
                  <a:gd name="T63" fmla="*/ 451 h 1130"/>
                  <a:gd name="T64" fmla="*/ 1217 w 1217"/>
                  <a:gd name="T65" fmla="*/ 454 h 1130"/>
                  <a:gd name="T66" fmla="*/ 0 w 1217"/>
                  <a:gd name="T67" fmla="*/ 454 h 1130"/>
                  <a:gd name="T68" fmla="*/ 0 w 1217"/>
                  <a:gd name="T69" fmla="*/ 451 h 1130"/>
                  <a:gd name="T70" fmla="*/ 0 w 1217"/>
                  <a:gd name="T71" fmla="*/ 339 h 1130"/>
                  <a:gd name="T72" fmla="*/ 1217 w 1217"/>
                  <a:gd name="T73" fmla="*/ 339 h 1130"/>
                  <a:gd name="T74" fmla="*/ 1217 w 1217"/>
                  <a:gd name="T75" fmla="*/ 341 h 1130"/>
                  <a:gd name="T76" fmla="*/ 0 w 1217"/>
                  <a:gd name="T77" fmla="*/ 341 h 1130"/>
                  <a:gd name="T78" fmla="*/ 0 w 1217"/>
                  <a:gd name="T79" fmla="*/ 339 h 1130"/>
                  <a:gd name="T80" fmla="*/ 0 w 1217"/>
                  <a:gd name="T81" fmla="*/ 226 h 1130"/>
                  <a:gd name="T82" fmla="*/ 1217 w 1217"/>
                  <a:gd name="T83" fmla="*/ 226 h 1130"/>
                  <a:gd name="T84" fmla="*/ 1217 w 1217"/>
                  <a:gd name="T85" fmla="*/ 228 h 1130"/>
                  <a:gd name="T86" fmla="*/ 0 w 1217"/>
                  <a:gd name="T87" fmla="*/ 228 h 1130"/>
                  <a:gd name="T88" fmla="*/ 0 w 1217"/>
                  <a:gd name="T89" fmla="*/ 226 h 1130"/>
                  <a:gd name="T90" fmla="*/ 0 w 1217"/>
                  <a:gd name="T91" fmla="*/ 113 h 1130"/>
                  <a:gd name="T92" fmla="*/ 1217 w 1217"/>
                  <a:gd name="T93" fmla="*/ 113 h 1130"/>
                  <a:gd name="T94" fmla="*/ 1217 w 1217"/>
                  <a:gd name="T95" fmla="*/ 116 h 1130"/>
                  <a:gd name="T96" fmla="*/ 0 w 1217"/>
                  <a:gd name="T97" fmla="*/ 116 h 1130"/>
                  <a:gd name="T98" fmla="*/ 0 w 1217"/>
                  <a:gd name="T99" fmla="*/ 113 h 1130"/>
                  <a:gd name="T100" fmla="*/ 0 w 1217"/>
                  <a:gd name="T101" fmla="*/ 0 h 1130"/>
                  <a:gd name="T102" fmla="*/ 1217 w 1217"/>
                  <a:gd name="T103" fmla="*/ 0 h 1130"/>
                  <a:gd name="T104" fmla="*/ 1217 w 1217"/>
                  <a:gd name="T105" fmla="*/ 3 h 1130"/>
                  <a:gd name="T106" fmla="*/ 0 w 1217"/>
                  <a:gd name="T107" fmla="*/ 3 h 1130"/>
                  <a:gd name="T108" fmla="*/ 0 w 1217"/>
                  <a:gd name="T109" fmla="*/ 0 h 1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1217" h="1130">
                    <a:moveTo>
                      <a:pt x="0" y="1127"/>
                    </a:moveTo>
                    <a:lnTo>
                      <a:pt x="1217" y="1127"/>
                    </a:lnTo>
                    <a:lnTo>
                      <a:pt x="1217" y="1130"/>
                    </a:lnTo>
                    <a:lnTo>
                      <a:pt x="0" y="1130"/>
                    </a:lnTo>
                    <a:lnTo>
                      <a:pt x="0" y="1127"/>
                    </a:lnTo>
                    <a:close/>
                    <a:moveTo>
                      <a:pt x="0" y="1014"/>
                    </a:moveTo>
                    <a:lnTo>
                      <a:pt x="1217" y="1014"/>
                    </a:lnTo>
                    <a:lnTo>
                      <a:pt x="1217" y="1017"/>
                    </a:lnTo>
                    <a:lnTo>
                      <a:pt x="0" y="1017"/>
                    </a:lnTo>
                    <a:lnTo>
                      <a:pt x="0" y="1014"/>
                    </a:lnTo>
                    <a:close/>
                    <a:moveTo>
                      <a:pt x="0" y="902"/>
                    </a:moveTo>
                    <a:lnTo>
                      <a:pt x="1217" y="902"/>
                    </a:lnTo>
                    <a:lnTo>
                      <a:pt x="1217" y="905"/>
                    </a:lnTo>
                    <a:lnTo>
                      <a:pt x="0" y="905"/>
                    </a:lnTo>
                    <a:lnTo>
                      <a:pt x="0" y="902"/>
                    </a:lnTo>
                    <a:close/>
                    <a:moveTo>
                      <a:pt x="0" y="789"/>
                    </a:moveTo>
                    <a:lnTo>
                      <a:pt x="1217" y="789"/>
                    </a:lnTo>
                    <a:lnTo>
                      <a:pt x="1217" y="792"/>
                    </a:lnTo>
                    <a:lnTo>
                      <a:pt x="0" y="792"/>
                    </a:lnTo>
                    <a:lnTo>
                      <a:pt x="0" y="789"/>
                    </a:lnTo>
                    <a:close/>
                    <a:moveTo>
                      <a:pt x="0" y="676"/>
                    </a:moveTo>
                    <a:lnTo>
                      <a:pt x="1217" y="676"/>
                    </a:lnTo>
                    <a:lnTo>
                      <a:pt x="1217" y="679"/>
                    </a:lnTo>
                    <a:lnTo>
                      <a:pt x="0" y="679"/>
                    </a:lnTo>
                    <a:lnTo>
                      <a:pt x="0" y="676"/>
                    </a:lnTo>
                    <a:close/>
                    <a:moveTo>
                      <a:pt x="0" y="564"/>
                    </a:moveTo>
                    <a:lnTo>
                      <a:pt x="1217" y="564"/>
                    </a:lnTo>
                    <a:lnTo>
                      <a:pt x="1217" y="566"/>
                    </a:lnTo>
                    <a:lnTo>
                      <a:pt x="0" y="566"/>
                    </a:lnTo>
                    <a:lnTo>
                      <a:pt x="0" y="564"/>
                    </a:lnTo>
                    <a:close/>
                    <a:moveTo>
                      <a:pt x="0" y="451"/>
                    </a:moveTo>
                    <a:lnTo>
                      <a:pt x="1217" y="451"/>
                    </a:lnTo>
                    <a:lnTo>
                      <a:pt x="1217" y="454"/>
                    </a:lnTo>
                    <a:lnTo>
                      <a:pt x="0" y="454"/>
                    </a:lnTo>
                    <a:lnTo>
                      <a:pt x="0" y="451"/>
                    </a:lnTo>
                    <a:close/>
                    <a:moveTo>
                      <a:pt x="0" y="339"/>
                    </a:moveTo>
                    <a:lnTo>
                      <a:pt x="1217" y="339"/>
                    </a:lnTo>
                    <a:lnTo>
                      <a:pt x="1217" y="341"/>
                    </a:lnTo>
                    <a:lnTo>
                      <a:pt x="0" y="341"/>
                    </a:lnTo>
                    <a:lnTo>
                      <a:pt x="0" y="339"/>
                    </a:lnTo>
                    <a:close/>
                    <a:moveTo>
                      <a:pt x="0" y="226"/>
                    </a:moveTo>
                    <a:lnTo>
                      <a:pt x="1217" y="226"/>
                    </a:lnTo>
                    <a:lnTo>
                      <a:pt x="1217" y="228"/>
                    </a:lnTo>
                    <a:lnTo>
                      <a:pt x="0" y="228"/>
                    </a:lnTo>
                    <a:lnTo>
                      <a:pt x="0" y="226"/>
                    </a:lnTo>
                    <a:close/>
                    <a:moveTo>
                      <a:pt x="0" y="113"/>
                    </a:moveTo>
                    <a:lnTo>
                      <a:pt x="1217" y="113"/>
                    </a:lnTo>
                    <a:lnTo>
                      <a:pt x="1217" y="116"/>
                    </a:lnTo>
                    <a:lnTo>
                      <a:pt x="0" y="116"/>
                    </a:lnTo>
                    <a:lnTo>
                      <a:pt x="0" y="113"/>
                    </a:lnTo>
                    <a:close/>
                    <a:moveTo>
                      <a:pt x="0" y="0"/>
                    </a:moveTo>
                    <a:lnTo>
                      <a:pt x="1217" y="0"/>
                    </a:lnTo>
                    <a:lnTo>
                      <a:pt x="1217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9D9D9"/>
              </a:solidFill>
              <a:ln w="1588" cap="flat">
                <a:solidFill>
                  <a:srgbClr val="D9D9D9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" name="Freeform 26"/>
              <p:cNvSpPr>
                <a:spLocks noEditPoints="1"/>
              </p:cNvSpPr>
              <p:nvPr/>
            </p:nvSpPr>
            <p:spPr bwMode="auto">
              <a:xfrm>
                <a:off x="655" y="-16"/>
                <a:ext cx="4241" cy="3531"/>
              </a:xfrm>
              <a:custGeom>
                <a:avLst/>
                <a:gdLst>
                  <a:gd name="T0" fmla="*/ 0 w 19208"/>
                  <a:gd name="T1" fmla="*/ 24 h 19032"/>
                  <a:gd name="T2" fmla="*/ 24 w 19208"/>
                  <a:gd name="T3" fmla="*/ 0 h 19032"/>
                  <a:gd name="T4" fmla="*/ 19184 w 19208"/>
                  <a:gd name="T5" fmla="*/ 0 h 19032"/>
                  <a:gd name="T6" fmla="*/ 19208 w 19208"/>
                  <a:gd name="T7" fmla="*/ 24 h 19032"/>
                  <a:gd name="T8" fmla="*/ 19208 w 19208"/>
                  <a:gd name="T9" fmla="*/ 19008 h 19032"/>
                  <a:gd name="T10" fmla="*/ 19184 w 19208"/>
                  <a:gd name="T11" fmla="*/ 19032 h 19032"/>
                  <a:gd name="T12" fmla="*/ 24 w 19208"/>
                  <a:gd name="T13" fmla="*/ 19032 h 19032"/>
                  <a:gd name="T14" fmla="*/ 0 w 19208"/>
                  <a:gd name="T15" fmla="*/ 19008 h 19032"/>
                  <a:gd name="T16" fmla="*/ 0 w 19208"/>
                  <a:gd name="T17" fmla="*/ 24 h 19032"/>
                  <a:gd name="T18" fmla="*/ 48 w 19208"/>
                  <a:gd name="T19" fmla="*/ 19008 h 19032"/>
                  <a:gd name="T20" fmla="*/ 24 w 19208"/>
                  <a:gd name="T21" fmla="*/ 18984 h 19032"/>
                  <a:gd name="T22" fmla="*/ 19184 w 19208"/>
                  <a:gd name="T23" fmla="*/ 18984 h 19032"/>
                  <a:gd name="T24" fmla="*/ 19160 w 19208"/>
                  <a:gd name="T25" fmla="*/ 19008 h 19032"/>
                  <a:gd name="T26" fmla="*/ 19160 w 19208"/>
                  <a:gd name="T27" fmla="*/ 24 h 19032"/>
                  <a:gd name="T28" fmla="*/ 19184 w 19208"/>
                  <a:gd name="T29" fmla="*/ 48 h 19032"/>
                  <a:gd name="T30" fmla="*/ 24 w 19208"/>
                  <a:gd name="T31" fmla="*/ 48 h 19032"/>
                  <a:gd name="T32" fmla="*/ 48 w 19208"/>
                  <a:gd name="T33" fmla="*/ 24 h 19032"/>
                  <a:gd name="T34" fmla="*/ 48 w 19208"/>
                  <a:gd name="T35" fmla="*/ 19008 h 190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208" h="19032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19184" y="0"/>
                    </a:lnTo>
                    <a:cubicBezTo>
                      <a:pt x="19198" y="0"/>
                      <a:pt x="19208" y="11"/>
                      <a:pt x="19208" y="24"/>
                    </a:cubicBezTo>
                    <a:lnTo>
                      <a:pt x="19208" y="19008"/>
                    </a:lnTo>
                    <a:cubicBezTo>
                      <a:pt x="19208" y="19022"/>
                      <a:pt x="19198" y="19032"/>
                      <a:pt x="19184" y="19032"/>
                    </a:cubicBezTo>
                    <a:lnTo>
                      <a:pt x="24" y="19032"/>
                    </a:lnTo>
                    <a:cubicBezTo>
                      <a:pt x="11" y="19032"/>
                      <a:pt x="0" y="19022"/>
                      <a:pt x="0" y="19008"/>
                    </a:cubicBezTo>
                    <a:lnTo>
                      <a:pt x="0" y="24"/>
                    </a:lnTo>
                    <a:close/>
                    <a:moveTo>
                      <a:pt x="48" y="19008"/>
                    </a:moveTo>
                    <a:lnTo>
                      <a:pt x="24" y="18984"/>
                    </a:lnTo>
                    <a:lnTo>
                      <a:pt x="19184" y="18984"/>
                    </a:lnTo>
                    <a:lnTo>
                      <a:pt x="19160" y="19008"/>
                    </a:lnTo>
                    <a:lnTo>
                      <a:pt x="19160" y="24"/>
                    </a:lnTo>
                    <a:lnTo>
                      <a:pt x="19184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1900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" name="Rectangle 27"/>
              <p:cNvSpPr>
                <a:spLocks noChangeArrowheads="1"/>
              </p:cNvSpPr>
              <p:nvPr/>
            </p:nvSpPr>
            <p:spPr bwMode="auto">
              <a:xfrm>
                <a:off x="711" y="427"/>
                <a:ext cx="52" cy="3084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" name="Rectangle 28"/>
              <p:cNvSpPr>
                <a:spLocks noChangeArrowheads="1"/>
              </p:cNvSpPr>
              <p:nvPr/>
            </p:nvSpPr>
            <p:spPr bwMode="auto">
              <a:xfrm>
                <a:off x="871" y="765"/>
                <a:ext cx="49" cy="2747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" name="Rectangle 29"/>
              <p:cNvSpPr>
                <a:spLocks noChangeArrowheads="1"/>
              </p:cNvSpPr>
              <p:nvPr/>
            </p:nvSpPr>
            <p:spPr bwMode="auto">
              <a:xfrm>
                <a:off x="1027" y="2683"/>
                <a:ext cx="49" cy="828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" name="Rectangle 30"/>
              <p:cNvSpPr>
                <a:spLocks noChangeArrowheads="1"/>
              </p:cNvSpPr>
              <p:nvPr/>
            </p:nvSpPr>
            <p:spPr bwMode="auto">
              <a:xfrm>
                <a:off x="1184" y="2718"/>
                <a:ext cx="49" cy="794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" name="Rectangle 31"/>
              <p:cNvSpPr>
                <a:spLocks noChangeArrowheads="1"/>
              </p:cNvSpPr>
              <p:nvPr/>
            </p:nvSpPr>
            <p:spPr bwMode="auto">
              <a:xfrm>
                <a:off x="1340" y="2752"/>
                <a:ext cx="49" cy="759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" name="Rectangle 32"/>
              <p:cNvSpPr>
                <a:spLocks noChangeArrowheads="1"/>
              </p:cNvSpPr>
              <p:nvPr/>
            </p:nvSpPr>
            <p:spPr bwMode="auto">
              <a:xfrm>
                <a:off x="1497" y="2787"/>
                <a:ext cx="49" cy="725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" name="Rectangle 33"/>
              <p:cNvSpPr>
                <a:spLocks noChangeArrowheads="1"/>
              </p:cNvSpPr>
              <p:nvPr/>
            </p:nvSpPr>
            <p:spPr bwMode="auto">
              <a:xfrm>
                <a:off x="1653" y="2858"/>
                <a:ext cx="49" cy="653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" name="Rectangle 34"/>
              <p:cNvSpPr>
                <a:spLocks noChangeArrowheads="1"/>
              </p:cNvSpPr>
              <p:nvPr/>
            </p:nvSpPr>
            <p:spPr bwMode="auto">
              <a:xfrm>
                <a:off x="1810" y="3387"/>
                <a:ext cx="49" cy="125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" name="Rectangle 35"/>
              <p:cNvSpPr>
                <a:spLocks noChangeArrowheads="1"/>
              </p:cNvSpPr>
              <p:nvPr/>
            </p:nvSpPr>
            <p:spPr bwMode="auto">
              <a:xfrm>
                <a:off x="1966" y="3421"/>
                <a:ext cx="49" cy="91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" name="Rectangle 36"/>
              <p:cNvSpPr>
                <a:spLocks noChangeArrowheads="1"/>
              </p:cNvSpPr>
              <p:nvPr/>
            </p:nvSpPr>
            <p:spPr bwMode="auto">
              <a:xfrm>
                <a:off x="2123" y="3458"/>
                <a:ext cx="52" cy="53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" name="Rectangle 37"/>
              <p:cNvSpPr>
                <a:spLocks noChangeArrowheads="1"/>
              </p:cNvSpPr>
              <p:nvPr/>
            </p:nvSpPr>
            <p:spPr bwMode="auto">
              <a:xfrm>
                <a:off x="2279" y="3474"/>
                <a:ext cx="49" cy="37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" name="Rectangle 38"/>
              <p:cNvSpPr>
                <a:spLocks noChangeArrowheads="1"/>
              </p:cNvSpPr>
              <p:nvPr/>
            </p:nvSpPr>
            <p:spPr bwMode="auto">
              <a:xfrm>
                <a:off x="2435" y="3474"/>
                <a:ext cx="52" cy="37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" name="Rectangle 39"/>
              <p:cNvSpPr>
                <a:spLocks noChangeArrowheads="1"/>
              </p:cNvSpPr>
              <p:nvPr/>
            </p:nvSpPr>
            <p:spPr bwMode="auto">
              <a:xfrm>
                <a:off x="2595" y="3474"/>
                <a:ext cx="49" cy="37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" name="Rectangle 40"/>
              <p:cNvSpPr>
                <a:spLocks noChangeArrowheads="1"/>
              </p:cNvSpPr>
              <p:nvPr/>
            </p:nvSpPr>
            <p:spPr bwMode="auto">
              <a:xfrm>
                <a:off x="2752" y="3493"/>
                <a:ext cx="45" cy="19"/>
              </a:xfrm>
              <a:prstGeom prst="rect">
                <a:avLst/>
              </a:prstGeom>
              <a:solidFill>
                <a:srgbClr val="FF99FF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8" name="Rectangle 41"/>
              <p:cNvSpPr>
                <a:spLocks noChangeArrowheads="1"/>
              </p:cNvSpPr>
              <p:nvPr/>
            </p:nvSpPr>
            <p:spPr bwMode="auto">
              <a:xfrm>
                <a:off x="2905" y="2171"/>
                <a:ext cx="52" cy="1340"/>
              </a:xfrm>
              <a:prstGeom prst="rect">
                <a:avLst/>
              </a:prstGeom>
              <a:solidFill>
                <a:srgbClr val="CCFF66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" name="Rectangle 42"/>
              <p:cNvSpPr>
                <a:spLocks noChangeArrowheads="1"/>
              </p:cNvSpPr>
              <p:nvPr/>
            </p:nvSpPr>
            <p:spPr bwMode="auto">
              <a:xfrm>
                <a:off x="3065" y="2490"/>
                <a:ext cx="49" cy="1022"/>
              </a:xfrm>
              <a:prstGeom prst="rect">
                <a:avLst/>
              </a:prstGeom>
              <a:solidFill>
                <a:srgbClr val="CCFF66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" name="Rectangle 43"/>
              <p:cNvSpPr>
                <a:spLocks noChangeArrowheads="1"/>
              </p:cNvSpPr>
              <p:nvPr/>
            </p:nvSpPr>
            <p:spPr bwMode="auto">
              <a:xfrm>
                <a:off x="3221" y="3087"/>
                <a:ext cx="49" cy="425"/>
              </a:xfrm>
              <a:prstGeom prst="rect">
                <a:avLst/>
              </a:prstGeom>
              <a:solidFill>
                <a:srgbClr val="CCFF66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" name="Rectangle 44"/>
              <p:cNvSpPr>
                <a:spLocks noChangeArrowheads="1"/>
              </p:cNvSpPr>
              <p:nvPr/>
            </p:nvSpPr>
            <p:spPr bwMode="auto">
              <a:xfrm>
                <a:off x="3378" y="3474"/>
                <a:ext cx="49" cy="37"/>
              </a:xfrm>
              <a:prstGeom prst="rect">
                <a:avLst/>
              </a:prstGeom>
              <a:solidFill>
                <a:srgbClr val="CCFF66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" name="Rectangle 45"/>
              <p:cNvSpPr>
                <a:spLocks noChangeArrowheads="1"/>
              </p:cNvSpPr>
              <p:nvPr/>
            </p:nvSpPr>
            <p:spPr bwMode="auto">
              <a:xfrm>
                <a:off x="3534" y="3493"/>
                <a:ext cx="49" cy="19"/>
              </a:xfrm>
              <a:prstGeom prst="rect">
                <a:avLst/>
              </a:prstGeom>
              <a:solidFill>
                <a:srgbClr val="CCFF66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3" name="Rectangle 46"/>
              <p:cNvSpPr>
                <a:spLocks noChangeArrowheads="1"/>
              </p:cNvSpPr>
              <p:nvPr/>
            </p:nvSpPr>
            <p:spPr bwMode="auto">
              <a:xfrm>
                <a:off x="3691" y="237"/>
                <a:ext cx="49" cy="3275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4" name="Rectangle 47"/>
              <p:cNvSpPr>
                <a:spLocks noChangeArrowheads="1"/>
              </p:cNvSpPr>
              <p:nvPr/>
            </p:nvSpPr>
            <p:spPr bwMode="auto">
              <a:xfrm>
                <a:off x="3847" y="340"/>
                <a:ext cx="52" cy="3172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5" name="Rectangle 48"/>
              <p:cNvSpPr>
                <a:spLocks noChangeArrowheads="1"/>
              </p:cNvSpPr>
              <p:nvPr/>
            </p:nvSpPr>
            <p:spPr bwMode="auto">
              <a:xfrm>
                <a:off x="4003" y="3174"/>
                <a:ext cx="49" cy="337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6" name="Rectangle 49"/>
              <p:cNvSpPr>
                <a:spLocks noChangeArrowheads="1"/>
              </p:cNvSpPr>
              <p:nvPr/>
            </p:nvSpPr>
            <p:spPr bwMode="auto">
              <a:xfrm>
                <a:off x="4160" y="3402"/>
                <a:ext cx="49" cy="109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" name="Rectangle 50"/>
              <p:cNvSpPr>
                <a:spLocks noChangeArrowheads="1"/>
              </p:cNvSpPr>
              <p:nvPr/>
            </p:nvSpPr>
            <p:spPr bwMode="auto">
              <a:xfrm>
                <a:off x="4316" y="3421"/>
                <a:ext cx="52" cy="91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" name="Rectangle 51"/>
              <p:cNvSpPr>
                <a:spLocks noChangeArrowheads="1"/>
              </p:cNvSpPr>
              <p:nvPr/>
            </p:nvSpPr>
            <p:spPr bwMode="auto">
              <a:xfrm>
                <a:off x="4476" y="3474"/>
                <a:ext cx="45" cy="37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" name="Rectangle 52"/>
              <p:cNvSpPr>
                <a:spLocks noChangeArrowheads="1"/>
              </p:cNvSpPr>
              <p:nvPr/>
            </p:nvSpPr>
            <p:spPr bwMode="auto">
              <a:xfrm>
                <a:off x="4629" y="3493"/>
                <a:ext cx="52" cy="19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Rectangle 53"/>
              <p:cNvSpPr>
                <a:spLocks noChangeArrowheads="1"/>
              </p:cNvSpPr>
              <p:nvPr/>
            </p:nvSpPr>
            <p:spPr bwMode="auto">
              <a:xfrm>
                <a:off x="4789" y="3493"/>
                <a:ext cx="49" cy="19"/>
              </a:xfrm>
              <a:prstGeom prst="rect">
                <a:avLst/>
              </a:prstGeom>
              <a:solidFill>
                <a:srgbClr val="FF9900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" name="Rectangle 54"/>
              <p:cNvSpPr>
                <a:spLocks noChangeArrowheads="1"/>
              </p:cNvSpPr>
              <p:nvPr/>
            </p:nvSpPr>
            <p:spPr bwMode="auto">
              <a:xfrm>
                <a:off x="471" y="3437"/>
                <a:ext cx="112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Rectangle 55"/>
              <p:cNvSpPr>
                <a:spLocks noChangeArrowheads="1"/>
              </p:cNvSpPr>
              <p:nvPr/>
            </p:nvSpPr>
            <p:spPr bwMode="auto">
              <a:xfrm>
                <a:off x="402" y="3083"/>
                <a:ext cx="225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Rectangle 56"/>
              <p:cNvSpPr>
                <a:spLocks noChangeArrowheads="1"/>
              </p:cNvSpPr>
              <p:nvPr/>
            </p:nvSpPr>
            <p:spPr bwMode="auto">
              <a:xfrm>
                <a:off x="402" y="2727"/>
                <a:ext cx="225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ectangle 57"/>
              <p:cNvSpPr>
                <a:spLocks noChangeArrowheads="1"/>
              </p:cNvSpPr>
              <p:nvPr/>
            </p:nvSpPr>
            <p:spPr bwMode="auto">
              <a:xfrm>
                <a:off x="402" y="2380"/>
                <a:ext cx="225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Rectangle 58"/>
              <p:cNvSpPr>
                <a:spLocks noChangeArrowheads="1"/>
              </p:cNvSpPr>
              <p:nvPr/>
            </p:nvSpPr>
            <p:spPr bwMode="auto">
              <a:xfrm>
                <a:off x="402" y="2027"/>
                <a:ext cx="225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Rectangle 59"/>
              <p:cNvSpPr>
                <a:spLocks noChangeArrowheads="1"/>
              </p:cNvSpPr>
              <p:nvPr/>
            </p:nvSpPr>
            <p:spPr bwMode="auto">
              <a:xfrm>
                <a:off x="336" y="1671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60"/>
              <p:cNvSpPr>
                <a:spLocks noChangeArrowheads="1"/>
              </p:cNvSpPr>
              <p:nvPr/>
            </p:nvSpPr>
            <p:spPr bwMode="auto">
              <a:xfrm>
                <a:off x="336" y="1324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Rectangle 61"/>
              <p:cNvSpPr>
                <a:spLocks noChangeArrowheads="1"/>
              </p:cNvSpPr>
              <p:nvPr/>
            </p:nvSpPr>
            <p:spPr bwMode="auto">
              <a:xfrm>
                <a:off x="336" y="971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62"/>
              <p:cNvSpPr>
                <a:spLocks noChangeArrowheads="1"/>
              </p:cNvSpPr>
              <p:nvPr/>
            </p:nvSpPr>
            <p:spPr bwMode="auto">
              <a:xfrm>
                <a:off x="336" y="615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Rectangle 63"/>
              <p:cNvSpPr>
                <a:spLocks noChangeArrowheads="1"/>
              </p:cNvSpPr>
              <p:nvPr/>
            </p:nvSpPr>
            <p:spPr bwMode="auto">
              <a:xfrm>
                <a:off x="336" y="268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Rectangle 64"/>
              <p:cNvSpPr>
                <a:spLocks noChangeArrowheads="1"/>
              </p:cNvSpPr>
              <p:nvPr/>
            </p:nvSpPr>
            <p:spPr bwMode="auto">
              <a:xfrm>
                <a:off x="336" y="-85"/>
                <a:ext cx="337" cy="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" name="文本框 41"/>
            <p:cNvSpPr txBox="1"/>
            <p:nvPr/>
          </p:nvSpPr>
          <p:spPr>
            <a:xfrm rot="12694542">
              <a:off x="376" y="3095"/>
              <a:ext cx="481" cy="137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 rot="12694542">
              <a:off x="618" y="3180"/>
              <a:ext cx="481" cy="91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aliz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 rot="12694542">
              <a:off x="662" y="3068"/>
              <a:ext cx="481" cy="150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logist regul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 rot="12694542">
              <a:off x="666" y="3028"/>
              <a:ext cx="481" cy="210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tablishment of localiz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 rot="12694542">
              <a:off x="753" y="3054"/>
              <a:ext cx="481" cy="225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ulation of biological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 rot="12694542">
              <a:off x="1124" y="3061"/>
              <a:ext cx="481" cy="161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onse to stimulu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 rot="12694542">
              <a:off x="1475" y="3143"/>
              <a:ext cx="481" cy="8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in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 rot="12694542">
              <a:off x="1022" y="2873"/>
              <a:ext cx="481" cy="330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component organization or biogen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 rot="12694542">
              <a:off x="1243" y="3013"/>
              <a:ext cx="481" cy="282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gative regulation of biological 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 rot="12694542">
              <a:off x="1710" y="3088"/>
              <a:ext cx="481" cy="172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-organism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 rot="12694542">
              <a:off x="2055" y="3114"/>
              <a:ext cx="481" cy="105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oduc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 rot="12694542">
              <a:off x="2073" y="3040"/>
              <a:ext cx="481" cy="166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oductive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 rot="12694542">
              <a:off x="1995" y="3116"/>
              <a:ext cx="481" cy="22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cellular organismal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 rot="12694542">
              <a:off x="263" y="3012"/>
              <a:ext cx="481" cy="137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 rot="12694542">
              <a:off x="2555" y="3164"/>
              <a:ext cx="481" cy="89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 rot="12694542">
              <a:off x="2724" y="3214"/>
              <a:ext cx="481" cy="7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ell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 rot="12694542">
              <a:off x="2642" y="3092"/>
              <a:ext cx="481" cy="183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romolecular complex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 rot="12694542">
              <a:off x="2880" y="3127"/>
              <a:ext cx="481" cy="147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ellular reg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 rot="12694542">
              <a:off x="2915" y="3142"/>
              <a:ext cx="481" cy="190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-enclosed lume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 rot="12694542">
              <a:off x="3229" y="3169"/>
              <a:ext cx="481" cy="127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talytic activity 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 rot="12694542">
              <a:off x="3530" y="3217"/>
              <a:ext cx="481" cy="65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ndin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 rot="12694542">
              <a:off x="3521" y="3062"/>
              <a:ext cx="481" cy="149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orte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 rot="12694542">
              <a:off x="3535" y="3074"/>
              <a:ext cx="481" cy="18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zyme regulato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 rot="12694542">
              <a:off x="3773" y="3111"/>
              <a:ext cx="481" cy="147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ocidan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 rot="12694542">
              <a:off x="3817" y="3107"/>
              <a:ext cx="481" cy="180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trient reservoi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/>
            <p:cNvSpPr txBox="1"/>
            <p:nvPr/>
          </p:nvSpPr>
          <p:spPr>
            <a:xfrm rot="12694542">
              <a:off x="3940" y="3028"/>
              <a:ext cx="481" cy="216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ecular transducer 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i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67"/>
            <p:cNvSpPr txBox="1"/>
            <p:nvPr/>
          </p:nvSpPr>
          <p:spPr>
            <a:xfrm rot="12694542">
              <a:off x="4106" y="3037"/>
              <a:ext cx="481" cy="216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ation regulator  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i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 rot="10800000">
              <a:off x="-52" y="1618"/>
              <a:ext cx="481" cy="115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gene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42" y="1054"/>
              <a:ext cx="364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264"/>
            <p:cNvSpPr>
              <a:spLocks noChangeArrowheads="1"/>
            </p:cNvSpPr>
            <p:nvPr/>
          </p:nvSpPr>
          <p:spPr bwMode="auto">
            <a:xfrm>
              <a:off x="745" y="12746"/>
              <a:ext cx="11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265"/>
            <p:cNvSpPr>
              <a:spLocks noChangeArrowheads="1"/>
            </p:cNvSpPr>
            <p:nvPr/>
          </p:nvSpPr>
          <p:spPr bwMode="auto">
            <a:xfrm>
              <a:off x="664" y="12507"/>
              <a:ext cx="220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266"/>
            <p:cNvSpPr>
              <a:spLocks noChangeArrowheads="1"/>
            </p:cNvSpPr>
            <p:nvPr/>
          </p:nvSpPr>
          <p:spPr bwMode="auto">
            <a:xfrm>
              <a:off x="582" y="12270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267"/>
            <p:cNvSpPr>
              <a:spLocks noChangeArrowheads="1"/>
            </p:cNvSpPr>
            <p:nvPr/>
          </p:nvSpPr>
          <p:spPr bwMode="auto">
            <a:xfrm>
              <a:off x="582" y="12029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268"/>
            <p:cNvSpPr>
              <a:spLocks noChangeArrowheads="1"/>
            </p:cNvSpPr>
            <p:nvPr/>
          </p:nvSpPr>
          <p:spPr bwMode="auto">
            <a:xfrm>
              <a:off x="582" y="11793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269"/>
            <p:cNvSpPr>
              <a:spLocks noChangeArrowheads="1"/>
            </p:cNvSpPr>
            <p:nvPr/>
          </p:nvSpPr>
          <p:spPr bwMode="auto">
            <a:xfrm>
              <a:off x="582" y="11556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270"/>
            <p:cNvSpPr>
              <a:spLocks noChangeArrowheads="1"/>
            </p:cNvSpPr>
            <p:nvPr/>
          </p:nvSpPr>
          <p:spPr bwMode="auto">
            <a:xfrm>
              <a:off x="582" y="11315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271"/>
            <p:cNvSpPr>
              <a:spLocks noChangeArrowheads="1"/>
            </p:cNvSpPr>
            <p:nvPr/>
          </p:nvSpPr>
          <p:spPr bwMode="auto">
            <a:xfrm>
              <a:off x="582" y="11079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272"/>
            <p:cNvSpPr>
              <a:spLocks noChangeArrowheads="1"/>
            </p:cNvSpPr>
            <p:nvPr/>
          </p:nvSpPr>
          <p:spPr bwMode="auto">
            <a:xfrm>
              <a:off x="582" y="10842"/>
              <a:ext cx="328" cy="1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0" lang="zh-CN" altLang="zh-CN" sz="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Freeform 278"/>
            <p:cNvSpPr>
              <a:spLocks noEditPoints="1"/>
            </p:cNvSpPr>
            <p:nvPr/>
          </p:nvSpPr>
          <p:spPr bwMode="auto">
            <a:xfrm>
              <a:off x="978" y="10892"/>
              <a:ext cx="4186" cy="1931"/>
            </a:xfrm>
            <a:custGeom>
              <a:avLst/>
              <a:gdLst>
                <a:gd name="T0" fmla="*/ 0 w 1234"/>
                <a:gd name="T1" fmla="*/ 1305 h 1309"/>
                <a:gd name="T2" fmla="*/ 1234 w 1234"/>
                <a:gd name="T3" fmla="*/ 1305 h 1309"/>
                <a:gd name="T4" fmla="*/ 1234 w 1234"/>
                <a:gd name="T5" fmla="*/ 1309 h 1309"/>
                <a:gd name="T6" fmla="*/ 0 w 1234"/>
                <a:gd name="T7" fmla="*/ 1309 h 1309"/>
                <a:gd name="T8" fmla="*/ 0 w 1234"/>
                <a:gd name="T9" fmla="*/ 1305 h 1309"/>
                <a:gd name="T10" fmla="*/ 0 w 1234"/>
                <a:gd name="T11" fmla="*/ 1141 h 1309"/>
                <a:gd name="T12" fmla="*/ 1234 w 1234"/>
                <a:gd name="T13" fmla="*/ 1141 h 1309"/>
                <a:gd name="T14" fmla="*/ 1234 w 1234"/>
                <a:gd name="T15" fmla="*/ 1145 h 1309"/>
                <a:gd name="T16" fmla="*/ 0 w 1234"/>
                <a:gd name="T17" fmla="*/ 1145 h 1309"/>
                <a:gd name="T18" fmla="*/ 0 w 1234"/>
                <a:gd name="T19" fmla="*/ 1141 h 1309"/>
                <a:gd name="T20" fmla="*/ 0 w 1234"/>
                <a:gd name="T21" fmla="*/ 978 h 1309"/>
                <a:gd name="T22" fmla="*/ 1234 w 1234"/>
                <a:gd name="T23" fmla="*/ 978 h 1309"/>
                <a:gd name="T24" fmla="*/ 1234 w 1234"/>
                <a:gd name="T25" fmla="*/ 982 h 1309"/>
                <a:gd name="T26" fmla="*/ 0 w 1234"/>
                <a:gd name="T27" fmla="*/ 982 h 1309"/>
                <a:gd name="T28" fmla="*/ 0 w 1234"/>
                <a:gd name="T29" fmla="*/ 978 h 1309"/>
                <a:gd name="T30" fmla="*/ 0 w 1234"/>
                <a:gd name="T31" fmla="*/ 815 h 1309"/>
                <a:gd name="T32" fmla="*/ 1234 w 1234"/>
                <a:gd name="T33" fmla="*/ 815 h 1309"/>
                <a:gd name="T34" fmla="*/ 1234 w 1234"/>
                <a:gd name="T35" fmla="*/ 819 h 1309"/>
                <a:gd name="T36" fmla="*/ 0 w 1234"/>
                <a:gd name="T37" fmla="*/ 819 h 1309"/>
                <a:gd name="T38" fmla="*/ 0 w 1234"/>
                <a:gd name="T39" fmla="*/ 815 h 1309"/>
                <a:gd name="T40" fmla="*/ 0 w 1234"/>
                <a:gd name="T41" fmla="*/ 652 h 1309"/>
                <a:gd name="T42" fmla="*/ 1234 w 1234"/>
                <a:gd name="T43" fmla="*/ 652 h 1309"/>
                <a:gd name="T44" fmla="*/ 1234 w 1234"/>
                <a:gd name="T45" fmla="*/ 656 h 1309"/>
                <a:gd name="T46" fmla="*/ 0 w 1234"/>
                <a:gd name="T47" fmla="*/ 656 h 1309"/>
                <a:gd name="T48" fmla="*/ 0 w 1234"/>
                <a:gd name="T49" fmla="*/ 652 h 1309"/>
                <a:gd name="T50" fmla="*/ 0 w 1234"/>
                <a:gd name="T51" fmla="*/ 489 h 1309"/>
                <a:gd name="T52" fmla="*/ 1234 w 1234"/>
                <a:gd name="T53" fmla="*/ 489 h 1309"/>
                <a:gd name="T54" fmla="*/ 1234 w 1234"/>
                <a:gd name="T55" fmla="*/ 493 h 1309"/>
                <a:gd name="T56" fmla="*/ 0 w 1234"/>
                <a:gd name="T57" fmla="*/ 493 h 1309"/>
                <a:gd name="T58" fmla="*/ 0 w 1234"/>
                <a:gd name="T59" fmla="*/ 489 h 1309"/>
                <a:gd name="T60" fmla="*/ 0 w 1234"/>
                <a:gd name="T61" fmla="*/ 326 h 1309"/>
                <a:gd name="T62" fmla="*/ 1234 w 1234"/>
                <a:gd name="T63" fmla="*/ 326 h 1309"/>
                <a:gd name="T64" fmla="*/ 1234 w 1234"/>
                <a:gd name="T65" fmla="*/ 330 h 1309"/>
                <a:gd name="T66" fmla="*/ 0 w 1234"/>
                <a:gd name="T67" fmla="*/ 330 h 1309"/>
                <a:gd name="T68" fmla="*/ 0 w 1234"/>
                <a:gd name="T69" fmla="*/ 326 h 1309"/>
                <a:gd name="T70" fmla="*/ 0 w 1234"/>
                <a:gd name="T71" fmla="*/ 163 h 1309"/>
                <a:gd name="T72" fmla="*/ 1234 w 1234"/>
                <a:gd name="T73" fmla="*/ 163 h 1309"/>
                <a:gd name="T74" fmla="*/ 1234 w 1234"/>
                <a:gd name="T75" fmla="*/ 167 h 1309"/>
                <a:gd name="T76" fmla="*/ 0 w 1234"/>
                <a:gd name="T77" fmla="*/ 167 h 1309"/>
                <a:gd name="T78" fmla="*/ 0 w 1234"/>
                <a:gd name="T79" fmla="*/ 163 h 1309"/>
                <a:gd name="T80" fmla="*/ 0 w 1234"/>
                <a:gd name="T81" fmla="*/ 0 h 1309"/>
                <a:gd name="T82" fmla="*/ 1234 w 1234"/>
                <a:gd name="T83" fmla="*/ 0 h 1309"/>
                <a:gd name="T84" fmla="*/ 1234 w 1234"/>
                <a:gd name="T85" fmla="*/ 3 h 1309"/>
                <a:gd name="T86" fmla="*/ 0 w 1234"/>
                <a:gd name="T87" fmla="*/ 3 h 1309"/>
                <a:gd name="T88" fmla="*/ 0 w 1234"/>
                <a:gd name="T89" fmla="*/ 0 h 13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1234" h="1309">
                  <a:moveTo>
                    <a:pt x="0" y="1305"/>
                  </a:moveTo>
                  <a:lnTo>
                    <a:pt x="1234" y="1305"/>
                  </a:lnTo>
                  <a:lnTo>
                    <a:pt x="1234" y="1309"/>
                  </a:lnTo>
                  <a:lnTo>
                    <a:pt x="0" y="1309"/>
                  </a:lnTo>
                  <a:lnTo>
                    <a:pt x="0" y="1305"/>
                  </a:lnTo>
                  <a:close/>
                  <a:moveTo>
                    <a:pt x="0" y="1141"/>
                  </a:moveTo>
                  <a:lnTo>
                    <a:pt x="1234" y="1141"/>
                  </a:lnTo>
                  <a:lnTo>
                    <a:pt x="1234" y="1145"/>
                  </a:lnTo>
                  <a:lnTo>
                    <a:pt x="0" y="1145"/>
                  </a:lnTo>
                  <a:lnTo>
                    <a:pt x="0" y="1141"/>
                  </a:lnTo>
                  <a:close/>
                  <a:moveTo>
                    <a:pt x="0" y="978"/>
                  </a:moveTo>
                  <a:lnTo>
                    <a:pt x="1234" y="978"/>
                  </a:lnTo>
                  <a:lnTo>
                    <a:pt x="1234" y="982"/>
                  </a:lnTo>
                  <a:lnTo>
                    <a:pt x="0" y="982"/>
                  </a:lnTo>
                  <a:lnTo>
                    <a:pt x="0" y="978"/>
                  </a:lnTo>
                  <a:close/>
                  <a:moveTo>
                    <a:pt x="0" y="815"/>
                  </a:moveTo>
                  <a:lnTo>
                    <a:pt x="1234" y="815"/>
                  </a:lnTo>
                  <a:lnTo>
                    <a:pt x="1234" y="819"/>
                  </a:lnTo>
                  <a:lnTo>
                    <a:pt x="0" y="819"/>
                  </a:lnTo>
                  <a:lnTo>
                    <a:pt x="0" y="815"/>
                  </a:lnTo>
                  <a:close/>
                  <a:moveTo>
                    <a:pt x="0" y="652"/>
                  </a:moveTo>
                  <a:lnTo>
                    <a:pt x="1234" y="652"/>
                  </a:lnTo>
                  <a:lnTo>
                    <a:pt x="1234" y="656"/>
                  </a:lnTo>
                  <a:lnTo>
                    <a:pt x="0" y="656"/>
                  </a:lnTo>
                  <a:lnTo>
                    <a:pt x="0" y="652"/>
                  </a:lnTo>
                  <a:close/>
                  <a:moveTo>
                    <a:pt x="0" y="489"/>
                  </a:moveTo>
                  <a:lnTo>
                    <a:pt x="1234" y="489"/>
                  </a:lnTo>
                  <a:lnTo>
                    <a:pt x="1234" y="493"/>
                  </a:lnTo>
                  <a:lnTo>
                    <a:pt x="0" y="493"/>
                  </a:lnTo>
                  <a:lnTo>
                    <a:pt x="0" y="489"/>
                  </a:lnTo>
                  <a:close/>
                  <a:moveTo>
                    <a:pt x="0" y="326"/>
                  </a:moveTo>
                  <a:lnTo>
                    <a:pt x="1234" y="326"/>
                  </a:lnTo>
                  <a:lnTo>
                    <a:pt x="1234" y="330"/>
                  </a:lnTo>
                  <a:lnTo>
                    <a:pt x="0" y="330"/>
                  </a:lnTo>
                  <a:lnTo>
                    <a:pt x="0" y="326"/>
                  </a:lnTo>
                  <a:close/>
                  <a:moveTo>
                    <a:pt x="0" y="163"/>
                  </a:moveTo>
                  <a:lnTo>
                    <a:pt x="1234" y="163"/>
                  </a:lnTo>
                  <a:lnTo>
                    <a:pt x="1234" y="167"/>
                  </a:lnTo>
                  <a:lnTo>
                    <a:pt x="0" y="167"/>
                  </a:lnTo>
                  <a:lnTo>
                    <a:pt x="0" y="163"/>
                  </a:lnTo>
                  <a:close/>
                  <a:moveTo>
                    <a:pt x="0" y="0"/>
                  </a:moveTo>
                  <a:lnTo>
                    <a:pt x="1234" y="0"/>
                  </a:lnTo>
                  <a:lnTo>
                    <a:pt x="1234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99FF"/>
            </a:solidFill>
            <a:ln w="1588" cap="flat">
              <a:solidFill>
                <a:srgbClr val="D9D9D9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2" name="Freeform 279"/>
            <p:cNvSpPr>
              <a:spLocks noEditPoints="1"/>
            </p:cNvSpPr>
            <p:nvPr/>
          </p:nvSpPr>
          <p:spPr bwMode="auto">
            <a:xfrm>
              <a:off x="974" y="10892"/>
              <a:ext cx="4196" cy="1931"/>
            </a:xfrm>
            <a:custGeom>
              <a:avLst/>
              <a:gdLst>
                <a:gd name="T0" fmla="*/ 0 w 18264"/>
                <a:gd name="T1" fmla="*/ 24 h 16488"/>
                <a:gd name="T2" fmla="*/ 24 w 18264"/>
                <a:gd name="T3" fmla="*/ 0 h 16488"/>
                <a:gd name="T4" fmla="*/ 18240 w 18264"/>
                <a:gd name="T5" fmla="*/ 0 h 16488"/>
                <a:gd name="T6" fmla="*/ 18264 w 18264"/>
                <a:gd name="T7" fmla="*/ 24 h 16488"/>
                <a:gd name="T8" fmla="*/ 18264 w 18264"/>
                <a:gd name="T9" fmla="*/ 16464 h 16488"/>
                <a:gd name="T10" fmla="*/ 18240 w 18264"/>
                <a:gd name="T11" fmla="*/ 16488 h 16488"/>
                <a:gd name="T12" fmla="*/ 24 w 18264"/>
                <a:gd name="T13" fmla="*/ 16488 h 16488"/>
                <a:gd name="T14" fmla="*/ 0 w 18264"/>
                <a:gd name="T15" fmla="*/ 16464 h 16488"/>
                <a:gd name="T16" fmla="*/ 0 w 18264"/>
                <a:gd name="T17" fmla="*/ 24 h 16488"/>
                <a:gd name="T18" fmla="*/ 48 w 18264"/>
                <a:gd name="T19" fmla="*/ 16464 h 16488"/>
                <a:gd name="T20" fmla="*/ 24 w 18264"/>
                <a:gd name="T21" fmla="*/ 16440 h 16488"/>
                <a:gd name="T22" fmla="*/ 18240 w 18264"/>
                <a:gd name="T23" fmla="*/ 16440 h 16488"/>
                <a:gd name="T24" fmla="*/ 18216 w 18264"/>
                <a:gd name="T25" fmla="*/ 16464 h 16488"/>
                <a:gd name="T26" fmla="*/ 18216 w 18264"/>
                <a:gd name="T27" fmla="*/ 24 h 16488"/>
                <a:gd name="T28" fmla="*/ 18240 w 18264"/>
                <a:gd name="T29" fmla="*/ 48 h 16488"/>
                <a:gd name="T30" fmla="*/ 24 w 18264"/>
                <a:gd name="T31" fmla="*/ 48 h 16488"/>
                <a:gd name="T32" fmla="*/ 48 w 18264"/>
                <a:gd name="T33" fmla="*/ 24 h 16488"/>
                <a:gd name="T34" fmla="*/ 48 w 18264"/>
                <a:gd name="T35" fmla="*/ 16464 h 164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8264" h="16488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18240" y="0"/>
                  </a:lnTo>
                  <a:cubicBezTo>
                    <a:pt x="18254" y="0"/>
                    <a:pt x="18264" y="11"/>
                    <a:pt x="18264" y="24"/>
                  </a:cubicBezTo>
                  <a:lnTo>
                    <a:pt x="18264" y="16464"/>
                  </a:lnTo>
                  <a:cubicBezTo>
                    <a:pt x="18264" y="16478"/>
                    <a:pt x="18254" y="16488"/>
                    <a:pt x="18240" y="16488"/>
                  </a:cubicBezTo>
                  <a:lnTo>
                    <a:pt x="24" y="16488"/>
                  </a:lnTo>
                  <a:cubicBezTo>
                    <a:pt x="11" y="16488"/>
                    <a:pt x="0" y="16478"/>
                    <a:pt x="0" y="16464"/>
                  </a:cubicBezTo>
                  <a:lnTo>
                    <a:pt x="0" y="24"/>
                  </a:lnTo>
                  <a:close/>
                  <a:moveTo>
                    <a:pt x="48" y="16464"/>
                  </a:moveTo>
                  <a:lnTo>
                    <a:pt x="24" y="16440"/>
                  </a:lnTo>
                  <a:lnTo>
                    <a:pt x="18240" y="16440"/>
                  </a:lnTo>
                  <a:lnTo>
                    <a:pt x="18216" y="16464"/>
                  </a:lnTo>
                  <a:lnTo>
                    <a:pt x="18216" y="24"/>
                  </a:lnTo>
                  <a:lnTo>
                    <a:pt x="18240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6464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3" name="Rectangle 280"/>
            <p:cNvSpPr>
              <a:spLocks noChangeArrowheads="1"/>
            </p:cNvSpPr>
            <p:nvPr/>
          </p:nvSpPr>
          <p:spPr bwMode="auto">
            <a:xfrm>
              <a:off x="1035" y="11568"/>
              <a:ext cx="54" cy="1252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4" name="Rectangle 282"/>
            <p:cNvSpPr>
              <a:spLocks noChangeArrowheads="1"/>
            </p:cNvSpPr>
            <p:nvPr/>
          </p:nvSpPr>
          <p:spPr bwMode="auto">
            <a:xfrm>
              <a:off x="1202" y="11765"/>
              <a:ext cx="54" cy="1054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5" name="Rectangle 284"/>
            <p:cNvSpPr>
              <a:spLocks noChangeArrowheads="1"/>
            </p:cNvSpPr>
            <p:nvPr/>
          </p:nvSpPr>
          <p:spPr bwMode="auto">
            <a:xfrm>
              <a:off x="1371" y="12501"/>
              <a:ext cx="54" cy="319"/>
            </a:xfrm>
            <a:prstGeom prst="rect">
              <a:avLst/>
            </a:prstGeom>
            <a:solidFill>
              <a:srgbClr val="FF99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6" name="Freeform 285"/>
            <p:cNvSpPr>
              <a:spLocks noEditPoints="1"/>
            </p:cNvSpPr>
            <p:nvPr/>
          </p:nvSpPr>
          <p:spPr bwMode="auto">
            <a:xfrm>
              <a:off x="1364" y="12498"/>
              <a:ext cx="64" cy="324"/>
            </a:xfrm>
            <a:custGeom>
              <a:avLst/>
              <a:gdLst>
                <a:gd name="T0" fmla="*/ 0 w 280"/>
                <a:gd name="T1" fmla="*/ 24 h 2760"/>
                <a:gd name="T2" fmla="*/ 24 w 280"/>
                <a:gd name="T3" fmla="*/ 0 h 2760"/>
                <a:gd name="T4" fmla="*/ 256 w 280"/>
                <a:gd name="T5" fmla="*/ 0 h 2760"/>
                <a:gd name="T6" fmla="*/ 280 w 280"/>
                <a:gd name="T7" fmla="*/ 24 h 2760"/>
                <a:gd name="T8" fmla="*/ 280 w 280"/>
                <a:gd name="T9" fmla="*/ 2736 h 2760"/>
                <a:gd name="T10" fmla="*/ 256 w 280"/>
                <a:gd name="T11" fmla="*/ 2760 h 2760"/>
                <a:gd name="T12" fmla="*/ 24 w 280"/>
                <a:gd name="T13" fmla="*/ 2760 h 2760"/>
                <a:gd name="T14" fmla="*/ 0 w 280"/>
                <a:gd name="T15" fmla="*/ 2736 h 2760"/>
                <a:gd name="T16" fmla="*/ 0 w 280"/>
                <a:gd name="T17" fmla="*/ 24 h 2760"/>
                <a:gd name="T18" fmla="*/ 48 w 280"/>
                <a:gd name="T19" fmla="*/ 2736 h 2760"/>
                <a:gd name="T20" fmla="*/ 24 w 280"/>
                <a:gd name="T21" fmla="*/ 2712 h 2760"/>
                <a:gd name="T22" fmla="*/ 256 w 280"/>
                <a:gd name="T23" fmla="*/ 2712 h 2760"/>
                <a:gd name="T24" fmla="*/ 232 w 280"/>
                <a:gd name="T25" fmla="*/ 2736 h 2760"/>
                <a:gd name="T26" fmla="*/ 232 w 280"/>
                <a:gd name="T27" fmla="*/ 24 h 2760"/>
                <a:gd name="T28" fmla="*/ 256 w 280"/>
                <a:gd name="T29" fmla="*/ 48 h 2760"/>
                <a:gd name="T30" fmla="*/ 24 w 280"/>
                <a:gd name="T31" fmla="*/ 48 h 2760"/>
                <a:gd name="T32" fmla="*/ 48 w 280"/>
                <a:gd name="T33" fmla="*/ 24 h 2760"/>
                <a:gd name="T34" fmla="*/ 48 w 280"/>
                <a:gd name="T35" fmla="*/ 2736 h 27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80" h="2760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256" y="0"/>
                  </a:lnTo>
                  <a:cubicBezTo>
                    <a:pt x="270" y="0"/>
                    <a:pt x="280" y="11"/>
                    <a:pt x="280" y="24"/>
                  </a:cubicBezTo>
                  <a:lnTo>
                    <a:pt x="280" y="2736"/>
                  </a:lnTo>
                  <a:cubicBezTo>
                    <a:pt x="280" y="2750"/>
                    <a:pt x="270" y="2760"/>
                    <a:pt x="256" y="2760"/>
                  </a:cubicBezTo>
                  <a:lnTo>
                    <a:pt x="24" y="2760"/>
                  </a:lnTo>
                  <a:cubicBezTo>
                    <a:pt x="11" y="2760"/>
                    <a:pt x="0" y="2750"/>
                    <a:pt x="0" y="2736"/>
                  </a:cubicBezTo>
                  <a:lnTo>
                    <a:pt x="0" y="24"/>
                  </a:lnTo>
                  <a:close/>
                  <a:moveTo>
                    <a:pt x="48" y="2736"/>
                  </a:moveTo>
                  <a:lnTo>
                    <a:pt x="24" y="2712"/>
                  </a:lnTo>
                  <a:lnTo>
                    <a:pt x="256" y="2712"/>
                  </a:lnTo>
                  <a:lnTo>
                    <a:pt x="232" y="2736"/>
                  </a:lnTo>
                  <a:lnTo>
                    <a:pt x="232" y="24"/>
                  </a:lnTo>
                  <a:lnTo>
                    <a:pt x="256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2736"/>
                  </a:lnTo>
                  <a:close/>
                </a:path>
              </a:pathLst>
            </a:custGeom>
            <a:solidFill>
              <a:srgbClr val="FF99FF"/>
            </a:solidFill>
            <a:ln w="1588" cap="flat">
              <a:solidFill>
                <a:srgbClr val="000000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7" name="Rectangle 286"/>
            <p:cNvSpPr>
              <a:spLocks noChangeArrowheads="1"/>
            </p:cNvSpPr>
            <p:nvPr/>
          </p:nvSpPr>
          <p:spPr bwMode="auto">
            <a:xfrm>
              <a:off x="1537" y="12512"/>
              <a:ext cx="54" cy="308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8" name="Rectangle 288"/>
            <p:cNvSpPr>
              <a:spLocks noChangeArrowheads="1"/>
            </p:cNvSpPr>
            <p:nvPr/>
          </p:nvSpPr>
          <p:spPr bwMode="auto">
            <a:xfrm>
              <a:off x="1706" y="12520"/>
              <a:ext cx="51" cy="299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89" name="Rectangle 290"/>
            <p:cNvSpPr>
              <a:spLocks noChangeArrowheads="1"/>
            </p:cNvSpPr>
            <p:nvPr/>
          </p:nvSpPr>
          <p:spPr bwMode="auto">
            <a:xfrm>
              <a:off x="1873" y="12535"/>
              <a:ext cx="51" cy="285"/>
            </a:xfrm>
            <a:prstGeom prst="rect">
              <a:avLst/>
            </a:prstGeom>
            <a:solidFill>
              <a:srgbClr val="FF99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0" name="Freeform 291"/>
            <p:cNvSpPr>
              <a:spLocks noEditPoints="1"/>
            </p:cNvSpPr>
            <p:nvPr/>
          </p:nvSpPr>
          <p:spPr bwMode="auto">
            <a:xfrm>
              <a:off x="1870" y="12532"/>
              <a:ext cx="61" cy="291"/>
            </a:xfrm>
            <a:custGeom>
              <a:avLst/>
              <a:gdLst>
                <a:gd name="T0" fmla="*/ 0 w 272"/>
                <a:gd name="T1" fmla="*/ 24 h 2472"/>
                <a:gd name="T2" fmla="*/ 24 w 272"/>
                <a:gd name="T3" fmla="*/ 0 h 2472"/>
                <a:gd name="T4" fmla="*/ 248 w 272"/>
                <a:gd name="T5" fmla="*/ 0 h 2472"/>
                <a:gd name="T6" fmla="*/ 272 w 272"/>
                <a:gd name="T7" fmla="*/ 24 h 2472"/>
                <a:gd name="T8" fmla="*/ 272 w 272"/>
                <a:gd name="T9" fmla="*/ 2448 h 2472"/>
                <a:gd name="T10" fmla="*/ 248 w 272"/>
                <a:gd name="T11" fmla="*/ 2472 h 2472"/>
                <a:gd name="T12" fmla="*/ 24 w 272"/>
                <a:gd name="T13" fmla="*/ 2472 h 2472"/>
                <a:gd name="T14" fmla="*/ 0 w 272"/>
                <a:gd name="T15" fmla="*/ 2448 h 2472"/>
                <a:gd name="T16" fmla="*/ 0 w 272"/>
                <a:gd name="T17" fmla="*/ 24 h 2472"/>
                <a:gd name="T18" fmla="*/ 48 w 272"/>
                <a:gd name="T19" fmla="*/ 2448 h 2472"/>
                <a:gd name="T20" fmla="*/ 24 w 272"/>
                <a:gd name="T21" fmla="*/ 2424 h 2472"/>
                <a:gd name="T22" fmla="*/ 248 w 272"/>
                <a:gd name="T23" fmla="*/ 2424 h 2472"/>
                <a:gd name="T24" fmla="*/ 224 w 272"/>
                <a:gd name="T25" fmla="*/ 2448 h 2472"/>
                <a:gd name="T26" fmla="*/ 224 w 272"/>
                <a:gd name="T27" fmla="*/ 24 h 2472"/>
                <a:gd name="T28" fmla="*/ 248 w 272"/>
                <a:gd name="T29" fmla="*/ 48 h 2472"/>
                <a:gd name="T30" fmla="*/ 24 w 272"/>
                <a:gd name="T31" fmla="*/ 48 h 2472"/>
                <a:gd name="T32" fmla="*/ 48 w 272"/>
                <a:gd name="T33" fmla="*/ 24 h 2472"/>
                <a:gd name="T34" fmla="*/ 48 w 272"/>
                <a:gd name="T35" fmla="*/ 2448 h 24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72" h="2472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248" y="0"/>
                  </a:lnTo>
                  <a:cubicBezTo>
                    <a:pt x="262" y="0"/>
                    <a:pt x="272" y="11"/>
                    <a:pt x="272" y="24"/>
                  </a:cubicBezTo>
                  <a:lnTo>
                    <a:pt x="272" y="2448"/>
                  </a:lnTo>
                  <a:cubicBezTo>
                    <a:pt x="272" y="2462"/>
                    <a:pt x="262" y="2472"/>
                    <a:pt x="248" y="2472"/>
                  </a:cubicBezTo>
                  <a:lnTo>
                    <a:pt x="24" y="2472"/>
                  </a:lnTo>
                  <a:cubicBezTo>
                    <a:pt x="11" y="2472"/>
                    <a:pt x="0" y="2462"/>
                    <a:pt x="0" y="2448"/>
                  </a:cubicBezTo>
                  <a:lnTo>
                    <a:pt x="0" y="24"/>
                  </a:lnTo>
                  <a:close/>
                  <a:moveTo>
                    <a:pt x="48" y="2448"/>
                  </a:moveTo>
                  <a:lnTo>
                    <a:pt x="24" y="2424"/>
                  </a:lnTo>
                  <a:lnTo>
                    <a:pt x="248" y="2424"/>
                  </a:lnTo>
                  <a:lnTo>
                    <a:pt x="224" y="2448"/>
                  </a:lnTo>
                  <a:lnTo>
                    <a:pt x="224" y="24"/>
                  </a:lnTo>
                  <a:lnTo>
                    <a:pt x="248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2448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1" name="Rectangle 292"/>
            <p:cNvSpPr>
              <a:spLocks noChangeArrowheads="1"/>
            </p:cNvSpPr>
            <p:nvPr/>
          </p:nvSpPr>
          <p:spPr bwMode="auto">
            <a:xfrm>
              <a:off x="2043" y="12635"/>
              <a:ext cx="51" cy="184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2" name="Rectangle 294"/>
            <p:cNvSpPr>
              <a:spLocks noChangeArrowheads="1"/>
            </p:cNvSpPr>
            <p:nvPr/>
          </p:nvSpPr>
          <p:spPr bwMode="auto">
            <a:xfrm>
              <a:off x="2209" y="12722"/>
              <a:ext cx="51" cy="97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3" name="Rectangle 296"/>
            <p:cNvSpPr>
              <a:spLocks noChangeArrowheads="1"/>
            </p:cNvSpPr>
            <p:nvPr/>
          </p:nvSpPr>
          <p:spPr bwMode="auto">
            <a:xfrm>
              <a:off x="2375" y="12790"/>
              <a:ext cx="51" cy="29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4" name="Rectangle 298"/>
            <p:cNvSpPr>
              <a:spLocks noChangeArrowheads="1"/>
            </p:cNvSpPr>
            <p:nvPr/>
          </p:nvSpPr>
          <p:spPr bwMode="auto">
            <a:xfrm>
              <a:off x="2545" y="12799"/>
              <a:ext cx="51" cy="21"/>
            </a:xfrm>
            <a:prstGeom prst="rect">
              <a:avLst/>
            </a:prstGeom>
            <a:solidFill>
              <a:srgbClr val="FF99FF"/>
            </a:solidFill>
            <a:ln w="9525">
              <a:solidFill>
                <a:srgbClr val="000000"/>
              </a:solidFill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5" name="Freeform 301"/>
            <p:cNvSpPr>
              <a:spLocks noEditPoints="1"/>
            </p:cNvSpPr>
            <p:nvPr/>
          </p:nvSpPr>
          <p:spPr bwMode="auto">
            <a:xfrm>
              <a:off x="2704" y="12796"/>
              <a:ext cx="64" cy="27"/>
            </a:xfrm>
            <a:custGeom>
              <a:avLst/>
              <a:gdLst>
                <a:gd name="T0" fmla="*/ 0 w 280"/>
                <a:gd name="T1" fmla="*/ 24 h 216"/>
                <a:gd name="T2" fmla="*/ 24 w 280"/>
                <a:gd name="T3" fmla="*/ 0 h 216"/>
                <a:gd name="T4" fmla="*/ 256 w 280"/>
                <a:gd name="T5" fmla="*/ 0 h 216"/>
                <a:gd name="T6" fmla="*/ 280 w 280"/>
                <a:gd name="T7" fmla="*/ 24 h 216"/>
                <a:gd name="T8" fmla="*/ 280 w 280"/>
                <a:gd name="T9" fmla="*/ 192 h 216"/>
                <a:gd name="T10" fmla="*/ 256 w 280"/>
                <a:gd name="T11" fmla="*/ 216 h 216"/>
                <a:gd name="T12" fmla="*/ 24 w 280"/>
                <a:gd name="T13" fmla="*/ 216 h 216"/>
                <a:gd name="T14" fmla="*/ 0 w 280"/>
                <a:gd name="T15" fmla="*/ 192 h 216"/>
                <a:gd name="T16" fmla="*/ 0 w 280"/>
                <a:gd name="T17" fmla="*/ 24 h 216"/>
                <a:gd name="T18" fmla="*/ 48 w 280"/>
                <a:gd name="T19" fmla="*/ 192 h 216"/>
                <a:gd name="T20" fmla="*/ 24 w 280"/>
                <a:gd name="T21" fmla="*/ 168 h 216"/>
                <a:gd name="T22" fmla="*/ 256 w 280"/>
                <a:gd name="T23" fmla="*/ 168 h 216"/>
                <a:gd name="T24" fmla="*/ 232 w 280"/>
                <a:gd name="T25" fmla="*/ 192 h 216"/>
                <a:gd name="T26" fmla="*/ 232 w 280"/>
                <a:gd name="T27" fmla="*/ 24 h 216"/>
                <a:gd name="T28" fmla="*/ 256 w 280"/>
                <a:gd name="T29" fmla="*/ 48 h 216"/>
                <a:gd name="T30" fmla="*/ 24 w 280"/>
                <a:gd name="T31" fmla="*/ 48 h 216"/>
                <a:gd name="T32" fmla="*/ 48 w 280"/>
                <a:gd name="T33" fmla="*/ 24 h 216"/>
                <a:gd name="T34" fmla="*/ 48 w 280"/>
                <a:gd name="T35" fmla="*/ 192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80" h="21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256" y="0"/>
                  </a:lnTo>
                  <a:cubicBezTo>
                    <a:pt x="270" y="0"/>
                    <a:pt x="280" y="11"/>
                    <a:pt x="280" y="24"/>
                  </a:cubicBezTo>
                  <a:lnTo>
                    <a:pt x="280" y="192"/>
                  </a:lnTo>
                  <a:cubicBezTo>
                    <a:pt x="280" y="206"/>
                    <a:pt x="270" y="216"/>
                    <a:pt x="256" y="216"/>
                  </a:cubicBezTo>
                  <a:lnTo>
                    <a:pt x="24" y="216"/>
                  </a:lnTo>
                  <a:cubicBezTo>
                    <a:pt x="11" y="216"/>
                    <a:pt x="0" y="206"/>
                    <a:pt x="0" y="192"/>
                  </a:cubicBezTo>
                  <a:lnTo>
                    <a:pt x="0" y="24"/>
                  </a:lnTo>
                  <a:close/>
                  <a:moveTo>
                    <a:pt x="48" y="192"/>
                  </a:moveTo>
                  <a:lnTo>
                    <a:pt x="24" y="168"/>
                  </a:lnTo>
                  <a:lnTo>
                    <a:pt x="256" y="168"/>
                  </a:lnTo>
                  <a:lnTo>
                    <a:pt x="232" y="192"/>
                  </a:lnTo>
                  <a:lnTo>
                    <a:pt x="232" y="24"/>
                  </a:lnTo>
                  <a:lnTo>
                    <a:pt x="256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92"/>
                  </a:lnTo>
                  <a:close/>
                </a:path>
              </a:pathLst>
            </a:custGeom>
            <a:solidFill>
              <a:srgbClr val="FF99FF"/>
            </a:solidFill>
            <a:ln w="1588" cap="flat">
              <a:solidFill>
                <a:srgbClr val="000000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6" name="Rectangle 302"/>
            <p:cNvSpPr>
              <a:spLocks noChangeArrowheads="1"/>
            </p:cNvSpPr>
            <p:nvPr/>
          </p:nvSpPr>
          <p:spPr bwMode="auto">
            <a:xfrm>
              <a:off x="2877" y="12799"/>
              <a:ext cx="54" cy="21"/>
            </a:xfrm>
            <a:prstGeom prst="rect">
              <a:avLst/>
            </a:prstGeom>
            <a:solidFill>
              <a:srgbClr val="FF99FF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7" name="Rectangle 304"/>
            <p:cNvSpPr>
              <a:spLocks noChangeArrowheads="1"/>
            </p:cNvSpPr>
            <p:nvPr/>
          </p:nvSpPr>
          <p:spPr bwMode="auto">
            <a:xfrm>
              <a:off x="3046" y="12809"/>
              <a:ext cx="51" cy="10"/>
            </a:xfrm>
            <a:prstGeom prst="rect">
              <a:avLst/>
            </a:pr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8" name="Freeform 305"/>
            <p:cNvSpPr>
              <a:spLocks noEditPoints="1"/>
            </p:cNvSpPr>
            <p:nvPr/>
          </p:nvSpPr>
          <p:spPr bwMode="auto">
            <a:xfrm>
              <a:off x="3040" y="12806"/>
              <a:ext cx="64" cy="16"/>
            </a:xfrm>
            <a:custGeom>
              <a:avLst/>
              <a:gdLst>
                <a:gd name="T0" fmla="*/ 0 w 280"/>
                <a:gd name="T1" fmla="*/ 24 h 136"/>
                <a:gd name="T2" fmla="*/ 24 w 280"/>
                <a:gd name="T3" fmla="*/ 0 h 136"/>
                <a:gd name="T4" fmla="*/ 256 w 280"/>
                <a:gd name="T5" fmla="*/ 0 h 136"/>
                <a:gd name="T6" fmla="*/ 280 w 280"/>
                <a:gd name="T7" fmla="*/ 24 h 136"/>
                <a:gd name="T8" fmla="*/ 280 w 280"/>
                <a:gd name="T9" fmla="*/ 112 h 136"/>
                <a:gd name="T10" fmla="*/ 256 w 280"/>
                <a:gd name="T11" fmla="*/ 136 h 136"/>
                <a:gd name="T12" fmla="*/ 24 w 280"/>
                <a:gd name="T13" fmla="*/ 136 h 136"/>
                <a:gd name="T14" fmla="*/ 0 w 280"/>
                <a:gd name="T15" fmla="*/ 112 h 136"/>
                <a:gd name="T16" fmla="*/ 0 w 280"/>
                <a:gd name="T17" fmla="*/ 24 h 136"/>
                <a:gd name="T18" fmla="*/ 48 w 280"/>
                <a:gd name="T19" fmla="*/ 112 h 136"/>
                <a:gd name="T20" fmla="*/ 24 w 280"/>
                <a:gd name="T21" fmla="*/ 88 h 136"/>
                <a:gd name="T22" fmla="*/ 256 w 280"/>
                <a:gd name="T23" fmla="*/ 88 h 136"/>
                <a:gd name="T24" fmla="*/ 232 w 280"/>
                <a:gd name="T25" fmla="*/ 112 h 136"/>
                <a:gd name="T26" fmla="*/ 232 w 280"/>
                <a:gd name="T27" fmla="*/ 24 h 136"/>
                <a:gd name="T28" fmla="*/ 256 w 280"/>
                <a:gd name="T29" fmla="*/ 48 h 136"/>
                <a:gd name="T30" fmla="*/ 24 w 280"/>
                <a:gd name="T31" fmla="*/ 48 h 136"/>
                <a:gd name="T32" fmla="*/ 48 w 280"/>
                <a:gd name="T33" fmla="*/ 24 h 136"/>
                <a:gd name="T34" fmla="*/ 48 w 280"/>
                <a:gd name="T35" fmla="*/ 112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80" h="136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256" y="0"/>
                  </a:lnTo>
                  <a:cubicBezTo>
                    <a:pt x="270" y="0"/>
                    <a:pt x="280" y="11"/>
                    <a:pt x="280" y="24"/>
                  </a:cubicBezTo>
                  <a:lnTo>
                    <a:pt x="280" y="112"/>
                  </a:lnTo>
                  <a:cubicBezTo>
                    <a:pt x="280" y="126"/>
                    <a:pt x="270" y="136"/>
                    <a:pt x="256" y="136"/>
                  </a:cubicBezTo>
                  <a:lnTo>
                    <a:pt x="24" y="136"/>
                  </a:lnTo>
                  <a:cubicBezTo>
                    <a:pt x="11" y="136"/>
                    <a:pt x="0" y="126"/>
                    <a:pt x="0" y="112"/>
                  </a:cubicBezTo>
                  <a:lnTo>
                    <a:pt x="0" y="24"/>
                  </a:lnTo>
                  <a:close/>
                  <a:moveTo>
                    <a:pt x="48" y="112"/>
                  </a:moveTo>
                  <a:lnTo>
                    <a:pt x="24" y="88"/>
                  </a:lnTo>
                  <a:lnTo>
                    <a:pt x="256" y="88"/>
                  </a:lnTo>
                  <a:lnTo>
                    <a:pt x="232" y="112"/>
                  </a:lnTo>
                  <a:lnTo>
                    <a:pt x="232" y="24"/>
                  </a:lnTo>
                  <a:lnTo>
                    <a:pt x="256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12"/>
                  </a:lnTo>
                  <a:close/>
                </a:path>
              </a:pathLst>
            </a:custGeom>
            <a:solidFill>
              <a:srgbClr val="FF99FF"/>
            </a:solidFill>
            <a:ln w="1588" cap="flat">
              <a:solidFill>
                <a:srgbClr val="000000"/>
              </a:solidFill>
              <a:prstDash val="solid"/>
              <a:beve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99" name="Rectangle 306"/>
            <p:cNvSpPr>
              <a:spLocks noChangeArrowheads="1"/>
            </p:cNvSpPr>
            <p:nvPr/>
          </p:nvSpPr>
          <p:spPr bwMode="auto">
            <a:xfrm>
              <a:off x="3213" y="12352"/>
              <a:ext cx="54" cy="468"/>
            </a:xfrm>
            <a:prstGeom prst="rect">
              <a:avLst/>
            </a:prstGeom>
            <a:solidFill>
              <a:srgbClr val="CCFF66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0" name="Rectangle 308"/>
            <p:cNvSpPr>
              <a:spLocks noChangeArrowheads="1"/>
            </p:cNvSpPr>
            <p:nvPr/>
          </p:nvSpPr>
          <p:spPr bwMode="auto">
            <a:xfrm>
              <a:off x="3379" y="12410"/>
              <a:ext cx="54" cy="410"/>
            </a:xfrm>
            <a:prstGeom prst="rect">
              <a:avLst/>
            </a:prstGeom>
            <a:solidFill>
              <a:srgbClr val="CCFF66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1" name="Rectangle 310"/>
            <p:cNvSpPr>
              <a:spLocks noChangeArrowheads="1"/>
            </p:cNvSpPr>
            <p:nvPr/>
          </p:nvSpPr>
          <p:spPr bwMode="auto">
            <a:xfrm>
              <a:off x="3545" y="12559"/>
              <a:ext cx="54" cy="261"/>
            </a:xfrm>
            <a:prstGeom prst="rect">
              <a:avLst/>
            </a:prstGeom>
            <a:solidFill>
              <a:srgbClr val="CCFF66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2" name="Rectangle 312"/>
            <p:cNvSpPr>
              <a:spLocks noChangeArrowheads="1"/>
            </p:cNvSpPr>
            <p:nvPr/>
          </p:nvSpPr>
          <p:spPr bwMode="auto">
            <a:xfrm>
              <a:off x="3715" y="12775"/>
              <a:ext cx="54" cy="44"/>
            </a:xfrm>
            <a:prstGeom prst="rect">
              <a:avLst/>
            </a:prstGeom>
            <a:solidFill>
              <a:srgbClr val="CCFF66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3" name="Rectangle 314"/>
            <p:cNvSpPr>
              <a:spLocks noChangeArrowheads="1"/>
            </p:cNvSpPr>
            <p:nvPr/>
          </p:nvSpPr>
          <p:spPr bwMode="auto">
            <a:xfrm>
              <a:off x="3885" y="11130"/>
              <a:ext cx="51" cy="1690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4" name="Rectangle 316"/>
            <p:cNvSpPr>
              <a:spLocks noChangeArrowheads="1"/>
            </p:cNvSpPr>
            <p:nvPr/>
          </p:nvSpPr>
          <p:spPr bwMode="auto">
            <a:xfrm>
              <a:off x="4051" y="11482"/>
              <a:ext cx="51" cy="1338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5" name="Rectangle 318"/>
            <p:cNvSpPr>
              <a:spLocks noChangeArrowheads="1"/>
            </p:cNvSpPr>
            <p:nvPr/>
          </p:nvSpPr>
          <p:spPr bwMode="auto">
            <a:xfrm>
              <a:off x="4217" y="12601"/>
              <a:ext cx="51" cy="218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6" name="Rectangle 320"/>
            <p:cNvSpPr>
              <a:spLocks noChangeArrowheads="1"/>
            </p:cNvSpPr>
            <p:nvPr/>
          </p:nvSpPr>
          <p:spPr bwMode="auto">
            <a:xfrm>
              <a:off x="4386" y="12786"/>
              <a:ext cx="51" cy="34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7" name="Rectangle 322"/>
            <p:cNvSpPr>
              <a:spLocks noChangeArrowheads="1"/>
            </p:cNvSpPr>
            <p:nvPr/>
          </p:nvSpPr>
          <p:spPr bwMode="auto">
            <a:xfrm>
              <a:off x="4552" y="12790"/>
              <a:ext cx="51" cy="29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8" name="Rectangle 324"/>
            <p:cNvSpPr>
              <a:spLocks noChangeArrowheads="1"/>
            </p:cNvSpPr>
            <p:nvPr/>
          </p:nvSpPr>
          <p:spPr bwMode="auto">
            <a:xfrm>
              <a:off x="4719" y="12795"/>
              <a:ext cx="51" cy="25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09" name="Rectangle 326"/>
            <p:cNvSpPr>
              <a:spLocks noChangeArrowheads="1"/>
            </p:cNvSpPr>
            <p:nvPr/>
          </p:nvSpPr>
          <p:spPr bwMode="auto">
            <a:xfrm>
              <a:off x="4889" y="12804"/>
              <a:ext cx="51" cy="16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0" name="Rectangle 328"/>
            <p:cNvSpPr>
              <a:spLocks noChangeArrowheads="1"/>
            </p:cNvSpPr>
            <p:nvPr/>
          </p:nvSpPr>
          <p:spPr bwMode="auto">
            <a:xfrm>
              <a:off x="5055" y="12814"/>
              <a:ext cx="54" cy="6"/>
            </a:xfrm>
            <a:prstGeom prst="rect">
              <a:avLst/>
            </a:prstGeom>
            <a:solidFill>
              <a:srgbClr val="FF9900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1" name="文本框 110"/>
            <p:cNvSpPr txBox="1"/>
            <p:nvPr/>
          </p:nvSpPr>
          <p:spPr>
            <a:xfrm rot="12694542">
              <a:off x="568" y="12537"/>
              <a:ext cx="481" cy="137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文本框 111"/>
            <p:cNvSpPr txBox="1"/>
            <p:nvPr/>
          </p:nvSpPr>
          <p:spPr>
            <a:xfrm rot="12694542">
              <a:off x="700" y="12620"/>
              <a:ext cx="481" cy="13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文本框 112"/>
            <p:cNvSpPr txBox="1"/>
            <p:nvPr/>
          </p:nvSpPr>
          <p:spPr>
            <a:xfrm rot="12694542">
              <a:off x="952" y="12709"/>
              <a:ext cx="481" cy="8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aliz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文本框 113"/>
            <p:cNvSpPr txBox="1"/>
            <p:nvPr/>
          </p:nvSpPr>
          <p:spPr>
            <a:xfrm rot="12694542">
              <a:off x="866" y="12553"/>
              <a:ext cx="481" cy="20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establishment of localiz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文本框 114"/>
            <p:cNvSpPr txBox="1"/>
            <p:nvPr/>
          </p:nvSpPr>
          <p:spPr>
            <a:xfrm rot="12694542">
              <a:off x="1248" y="12374"/>
              <a:ext cx="481" cy="17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logical regul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/>
            <p:cNvSpPr txBox="1"/>
            <p:nvPr/>
          </p:nvSpPr>
          <p:spPr>
            <a:xfrm rot="12694542">
              <a:off x="1143" y="12598"/>
              <a:ext cx="481" cy="21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ulation of biological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/>
            <p:cNvSpPr txBox="1"/>
            <p:nvPr/>
          </p:nvSpPr>
          <p:spPr>
            <a:xfrm rot="12694542">
              <a:off x="1491" y="12670"/>
              <a:ext cx="481" cy="145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onse to stimulu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/>
            <p:cNvSpPr txBox="1"/>
            <p:nvPr/>
          </p:nvSpPr>
          <p:spPr>
            <a:xfrm rot="12694542">
              <a:off x="1233" y="12554"/>
              <a:ext cx="481" cy="311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ular component organization or biogen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/>
            <p:cNvSpPr txBox="1"/>
            <p:nvPr/>
          </p:nvSpPr>
          <p:spPr>
            <a:xfrm rot="12694542">
              <a:off x="2008" y="12727"/>
              <a:ext cx="481" cy="74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in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文本框 119"/>
            <p:cNvSpPr txBox="1"/>
            <p:nvPr/>
          </p:nvSpPr>
          <p:spPr>
            <a:xfrm rot="12694542">
              <a:off x="2113" y="12711"/>
              <a:ext cx="481" cy="96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oduc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文本框 120"/>
            <p:cNvSpPr txBox="1"/>
            <p:nvPr/>
          </p:nvSpPr>
          <p:spPr>
            <a:xfrm rot="12694542">
              <a:off x="2181" y="12603"/>
              <a:ext cx="481" cy="154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oductive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文本框 121"/>
            <p:cNvSpPr txBox="1"/>
            <p:nvPr/>
          </p:nvSpPr>
          <p:spPr>
            <a:xfrm rot="12694542">
              <a:off x="2285" y="12628"/>
              <a:ext cx="481" cy="167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-organism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文本框 122"/>
            <p:cNvSpPr txBox="1"/>
            <p:nvPr/>
          </p:nvSpPr>
          <p:spPr>
            <a:xfrm rot="12694542">
              <a:off x="2291" y="12597"/>
              <a:ext cx="481" cy="223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cellular organismal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文本框 123"/>
            <p:cNvSpPr txBox="1"/>
            <p:nvPr/>
          </p:nvSpPr>
          <p:spPr>
            <a:xfrm rot="12694542">
              <a:off x="2859" y="12691"/>
              <a:ext cx="481" cy="76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ell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 rot="12694542">
              <a:off x="2998" y="12682"/>
              <a:ext cx="481" cy="85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membran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 rot="12694542">
              <a:off x="2919" y="12621"/>
              <a:ext cx="481" cy="180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cromolecular complex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 rot="12694542">
              <a:off x="3204" y="12631"/>
              <a:ext cx="481" cy="14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tracellular reg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 rot="12694542">
              <a:off x="3561" y="12712"/>
              <a:ext cx="481" cy="66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ndin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 rot="12694542">
              <a:off x="3561" y="12690"/>
              <a:ext cx="481" cy="120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talytic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 rot="12694542">
              <a:off x="3700" y="12634"/>
              <a:ext cx="481" cy="13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porte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文本框 130"/>
            <p:cNvSpPr txBox="1"/>
            <p:nvPr/>
          </p:nvSpPr>
          <p:spPr>
            <a:xfrm rot="12694542">
              <a:off x="3869" y="12660"/>
              <a:ext cx="481" cy="139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oxidant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 rot="12694542">
              <a:off x="3939" y="12604"/>
              <a:ext cx="481" cy="182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zyme regulato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 rot="12694542">
              <a:off x="4069" y="12570"/>
              <a:ext cx="481" cy="19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uctural molecule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 rot="12694542">
              <a:off x="4267" y="12619"/>
              <a:ext cx="481" cy="178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nutrient reservoi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 rot="12694542">
              <a:off x="4383" y="12570"/>
              <a:ext cx="481" cy="207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molecular transducer activ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文本框 135"/>
            <p:cNvSpPr txBox="1"/>
            <p:nvPr/>
          </p:nvSpPr>
          <p:spPr>
            <a:xfrm rot="10800000">
              <a:off x="165" y="10633"/>
              <a:ext cx="481" cy="195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gene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136"/>
            <p:cNvSpPr txBox="1"/>
            <p:nvPr/>
          </p:nvSpPr>
          <p:spPr>
            <a:xfrm>
              <a:off x="5554" y="5604"/>
              <a:ext cx="4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4" name="组合 213"/>
            <p:cNvGrpSpPr/>
            <p:nvPr/>
          </p:nvGrpSpPr>
          <p:grpSpPr>
            <a:xfrm>
              <a:off x="144" y="5941"/>
              <a:ext cx="5158" cy="4880"/>
              <a:chOff x="-122" y="11643"/>
              <a:chExt cx="5194" cy="4880"/>
            </a:xfrm>
          </p:grpSpPr>
          <p:sp>
            <p:nvSpPr>
              <p:cNvPr id="181" name="文本框 180"/>
              <p:cNvSpPr txBox="1"/>
              <p:nvPr/>
            </p:nvSpPr>
            <p:spPr>
              <a:xfrm rot="12694542">
                <a:off x="298" y="13541"/>
                <a:ext cx="484" cy="114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ular proces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文本框 181"/>
              <p:cNvSpPr txBox="1"/>
              <p:nvPr/>
            </p:nvSpPr>
            <p:spPr>
              <a:xfrm rot="12694542">
                <a:off x="408" y="13452"/>
                <a:ext cx="484" cy="154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logical regula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文本框 182"/>
              <p:cNvSpPr txBox="1"/>
              <p:nvPr/>
            </p:nvSpPr>
            <p:spPr>
              <a:xfrm rot="12694542">
                <a:off x="866" y="13555"/>
                <a:ext cx="484" cy="92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caliza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文本框 183"/>
              <p:cNvSpPr txBox="1"/>
              <p:nvPr/>
            </p:nvSpPr>
            <p:spPr>
              <a:xfrm rot="12694542">
                <a:off x="738" y="13484"/>
                <a:ext cx="484" cy="198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ablishment of localiza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文本框 184"/>
              <p:cNvSpPr txBox="1"/>
              <p:nvPr/>
            </p:nvSpPr>
            <p:spPr>
              <a:xfrm rot="12694542">
                <a:off x="1036" y="13515"/>
                <a:ext cx="484" cy="147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ponse to stimulu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文本框 185"/>
              <p:cNvSpPr txBox="1"/>
              <p:nvPr/>
            </p:nvSpPr>
            <p:spPr>
              <a:xfrm rot="12694542">
                <a:off x="759" y="13401"/>
                <a:ext cx="484" cy="312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ular component organization or biogen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文本框 186"/>
              <p:cNvSpPr txBox="1"/>
              <p:nvPr/>
            </p:nvSpPr>
            <p:spPr>
              <a:xfrm rot="12694542">
                <a:off x="1543" y="13575"/>
                <a:ext cx="484" cy="74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gnalin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文本框 187"/>
              <p:cNvSpPr txBox="1"/>
              <p:nvPr/>
            </p:nvSpPr>
            <p:spPr>
              <a:xfrm rot="12694542">
                <a:off x="1649" y="13510"/>
                <a:ext cx="484" cy="103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roduc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文本框 188"/>
              <p:cNvSpPr txBox="1"/>
              <p:nvPr/>
            </p:nvSpPr>
            <p:spPr>
              <a:xfrm rot="12694542">
                <a:off x="1671" y="13504"/>
                <a:ext cx="484" cy="149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productive proces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文本框 189"/>
              <p:cNvSpPr txBox="1"/>
              <p:nvPr/>
            </p:nvSpPr>
            <p:spPr>
              <a:xfrm rot="12694542">
                <a:off x="1799" y="13442"/>
                <a:ext cx="484" cy="173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lti-organism proces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文本框 190"/>
              <p:cNvSpPr txBox="1"/>
              <p:nvPr/>
            </p:nvSpPr>
            <p:spPr>
              <a:xfrm rot="12694542">
                <a:off x="1809" y="13448"/>
                <a:ext cx="484" cy="225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lticellular organismal proces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文本框 191"/>
              <p:cNvSpPr txBox="1"/>
              <p:nvPr/>
            </p:nvSpPr>
            <p:spPr>
              <a:xfrm rot="12694542">
                <a:off x="1835" y="13421"/>
                <a:ext cx="484" cy="277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gative regulation of biological proces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文本框 192"/>
              <p:cNvSpPr txBox="1"/>
              <p:nvPr/>
            </p:nvSpPr>
            <p:spPr>
              <a:xfrm rot="12694542">
                <a:off x="2494" y="13581"/>
                <a:ext cx="484" cy="81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mbran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文本框 193"/>
              <p:cNvSpPr txBox="1"/>
              <p:nvPr/>
            </p:nvSpPr>
            <p:spPr>
              <a:xfrm rot="12694542">
                <a:off x="2673" y="13571"/>
                <a:ext cx="484" cy="79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rganell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文本框 194"/>
              <p:cNvSpPr txBox="1"/>
              <p:nvPr/>
            </p:nvSpPr>
            <p:spPr>
              <a:xfrm rot="12694542">
                <a:off x="2558" y="13524"/>
                <a:ext cx="484" cy="1771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cromolecular complex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文本框 195"/>
              <p:cNvSpPr txBox="1"/>
              <p:nvPr/>
            </p:nvSpPr>
            <p:spPr>
              <a:xfrm rot="12694542">
                <a:off x="2822" y="13525"/>
                <a:ext cx="484" cy="14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racellular reg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文本框 196"/>
              <p:cNvSpPr txBox="1"/>
              <p:nvPr/>
            </p:nvSpPr>
            <p:spPr>
              <a:xfrm rot="12694542">
                <a:off x="2870" y="13457"/>
                <a:ext cx="484" cy="191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mbrane-enclosed lume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文本框 197"/>
              <p:cNvSpPr txBox="1"/>
              <p:nvPr/>
            </p:nvSpPr>
            <p:spPr>
              <a:xfrm rot="12694542">
                <a:off x="3348" y="13553"/>
                <a:ext cx="484" cy="7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ndin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文本框 198"/>
              <p:cNvSpPr txBox="1"/>
              <p:nvPr/>
            </p:nvSpPr>
            <p:spPr>
              <a:xfrm rot="12694542">
                <a:off x="3359" y="13512"/>
                <a:ext cx="484" cy="126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talytic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文本框 199"/>
              <p:cNvSpPr txBox="1"/>
              <p:nvPr/>
            </p:nvSpPr>
            <p:spPr>
              <a:xfrm rot="12694542">
                <a:off x="3488" y="13468"/>
                <a:ext cx="484" cy="1437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nsporter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文本框 200"/>
              <p:cNvSpPr txBox="1"/>
              <p:nvPr/>
            </p:nvSpPr>
            <p:spPr>
              <a:xfrm rot="12694542">
                <a:off x="3521" y="13471"/>
                <a:ext cx="484" cy="181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zyme regulator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文本框 201"/>
              <p:cNvSpPr txBox="1"/>
              <p:nvPr/>
            </p:nvSpPr>
            <p:spPr>
              <a:xfrm rot="12694542">
                <a:off x="3806" y="13446"/>
                <a:ext cx="484" cy="1499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ioxidant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文本框 202"/>
              <p:cNvSpPr txBox="1"/>
              <p:nvPr/>
            </p:nvSpPr>
            <p:spPr>
              <a:xfrm rot="12694542">
                <a:off x="3846" y="13402"/>
                <a:ext cx="484" cy="20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ructural molecule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文本框 203"/>
              <p:cNvSpPr txBox="1"/>
              <p:nvPr/>
            </p:nvSpPr>
            <p:spPr>
              <a:xfrm rot="12694542">
                <a:off x="4052" y="13529"/>
                <a:ext cx="484" cy="164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ectron carrier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文本框 204"/>
              <p:cNvSpPr txBox="1"/>
              <p:nvPr/>
            </p:nvSpPr>
            <p:spPr>
              <a:xfrm rot="12694542">
                <a:off x="4219" y="13461"/>
                <a:ext cx="484" cy="1833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trient reservoir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文本框 205"/>
              <p:cNvSpPr txBox="1"/>
              <p:nvPr/>
            </p:nvSpPr>
            <p:spPr>
              <a:xfrm rot="12694542">
                <a:off x="4299" y="13404"/>
                <a:ext cx="484" cy="2195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lecular transducer activit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Freeform 344"/>
              <p:cNvSpPr>
                <a:spLocks noEditPoints="1"/>
              </p:cNvSpPr>
              <p:nvPr/>
            </p:nvSpPr>
            <p:spPr bwMode="auto">
              <a:xfrm>
                <a:off x="559" y="11694"/>
                <a:ext cx="4508" cy="2015"/>
              </a:xfrm>
              <a:custGeom>
                <a:avLst/>
                <a:gdLst>
                  <a:gd name="T0" fmla="*/ 0 w 1803"/>
                  <a:gd name="T1" fmla="*/ 1298 h 1303"/>
                  <a:gd name="T2" fmla="*/ 1803 w 1803"/>
                  <a:gd name="T3" fmla="*/ 1298 h 1303"/>
                  <a:gd name="T4" fmla="*/ 1803 w 1803"/>
                  <a:gd name="T5" fmla="*/ 1303 h 1303"/>
                  <a:gd name="T6" fmla="*/ 0 w 1803"/>
                  <a:gd name="T7" fmla="*/ 1303 h 1303"/>
                  <a:gd name="T8" fmla="*/ 0 w 1803"/>
                  <a:gd name="T9" fmla="*/ 1298 h 1303"/>
                  <a:gd name="T10" fmla="*/ 0 w 1803"/>
                  <a:gd name="T11" fmla="*/ 1154 h 1303"/>
                  <a:gd name="T12" fmla="*/ 1803 w 1803"/>
                  <a:gd name="T13" fmla="*/ 1154 h 1303"/>
                  <a:gd name="T14" fmla="*/ 1803 w 1803"/>
                  <a:gd name="T15" fmla="*/ 1158 h 1303"/>
                  <a:gd name="T16" fmla="*/ 0 w 1803"/>
                  <a:gd name="T17" fmla="*/ 1158 h 1303"/>
                  <a:gd name="T18" fmla="*/ 0 w 1803"/>
                  <a:gd name="T19" fmla="*/ 1154 h 1303"/>
                  <a:gd name="T20" fmla="*/ 0 w 1803"/>
                  <a:gd name="T21" fmla="*/ 1010 h 1303"/>
                  <a:gd name="T22" fmla="*/ 1803 w 1803"/>
                  <a:gd name="T23" fmla="*/ 1010 h 1303"/>
                  <a:gd name="T24" fmla="*/ 1803 w 1803"/>
                  <a:gd name="T25" fmla="*/ 1014 h 1303"/>
                  <a:gd name="T26" fmla="*/ 0 w 1803"/>
                  <a:gd name="T27" fmla="*/ 1014 h 1303"/>
                  <a:gd name="T28" fmla="*/ 0 w 1803"/>
                  <a:gd name="T29" fmla="*/ 1010 h 1303"/>
                  <a:gd name="T30" fmla="*/ 0 w 1803"/>
                  <a:gd name="T31" fmla="*/ 866 h 1303"/>
                  <a:gd name="T32" fmla="*/ 1803 w 1803"/>
                  <a:gd name="T33" fmla="*/ 866 h 1303"/>
                  <a:gd name="T34" fmla="*/ 1803 w 1803"/>
                  <a:gd name="T35" fmla="*/ 870 h 1303"/>
                  <a:gd name="T36" fmla="*/ 0 w 1803"/>
                  <a:gd name="T37" fmla="*/ 870 h 1303"/>
                  <a:gd name="T38" fmla="*/ 0 w 1803"/>
                  <a:gd name="T39" fmla="*/ 866 h 1303"/>
                  <a:gd name="T40" fmla="*/ 0 w 1803"/>
                  <a:gd name="T41" fmla="*/ 722 h 1303"/>
                  <a:gd name="T42" fmla="*/ 1803 w 1803"/>
                  <a:gd name="T43" fmla="*/ 722 h 1303"/>
                  <a:gd name="T44" fmla="*/ 1803 w 1803"/>
                  <a:gd name="T45" fmla="*/ 726 h 1303"/>
                  <a:gd name="T46" fmla="*/ 0 w 1803"/>
                  <a:gd name="T47" fmla="*/ 726 h 1303"/>
                  <a:gd name="T48" fmla="*/ 0 w 1803"/>
                  <a:gd name="T49" fmla="*/ 722 h 1303"/>
                  <a:gd name="T50" fmla="*/ 0 w 1803"/>
                  <a:gd name="T51" fmla="*/ 577 h 1303"/>
                  <a:gd name="T52" fmla="*/ 1803 w 1803"/>
                  <a:gd name="T53" fmla="*/ 577 h 1303"/>
                  <a:gd name="T54" fmla="*/ 1803 w 1803"/>
                  <a:gd name="T55" fmla="*/ 581 h 1303"/>
                  <a:gd name="T56" fmla="*/ 0 w 1803"/>
                  <a:gd name="T57" fmla="*/ 581 h 1303"/>
                  <a:gd name="T58" fmla="*/ 0 w 1803"/>
                  <a:gd name="T59" fmla="*/ 577 h 1303"/>
                  <a:gd name="T60" fmla="*/ 0 w 1803"/>
                  <a:gd name="T61" fmla="*/ 433 h 1303"/>
                  <a:gd name="T62" fmla="*/ 1803 w 1803"/>
                  <a:gd name="T63" fmla="*/ 433 h 1303"/>
                  <a:gd name="T64" fmla="*/ 1803 w 1803"/>
                  <a:gd name="T65" fmla="*/ 437 h 1303"/>
                  <a:gd name="T66" fmla="*/ 0 w 1803"/>
                  <a:gd name="T67" fmla="*/ 437 h 1303"/>
                  <a:gd name="T68" fmla="*/ 0 w 1803"/>
                  <a:gd name="T69" fmla="*/ 433 h 1303"/>
                  <a:gd name="T70" fmla="*/ 0 w 1803"/>
                  <a:gd name="T71" fmla="*/ 289 h 1303"/>
                  <a:gd name="T72" fmla="*/ 1803 w 1803"/>
                  <a:gd name="T73" fmla="*/ 289 h 1303"/>
                  <a:gd name="T74" fmla="*/ 1803 w 1803"/>
                  <a:gd name="T75" fmla="*/ 293 h 1303"/>
                  <a:gd name="T76" fmla="*/ 0 w 1803"/>
                  <a:gd name="T77" fmla="*/ 293 h 1303"/>
                  <a:gd name="T78" fmla="*/ 0 w 1803"/>
                  <a:gd name="T79" fmla="*/ 289 h 1303"/>
                  <a:gd name="T80" fmla="*/ 0 w 1803"/>
                  <a:gd name="T81" fmla="*/ 145 h 1303"/>
                  <a:gd name="T82" fmla="*/ 1803 w 1803"/>
                  <a:gd name="T83" fmla="*/ 145 h 1303"/>
                  <a:gd name="T84" fmla="*/ 1803 w 1803"/>
                  <a:gd name="T85" fmla="*/ 149 h 1303"/>
                  <a:gd name="T86" fmla="*/ 0 w 1803"/>
                  <a:gd name="T87" fmla="*/ 149 h 1303"/>
                  <a:gd name="T88" fmla="*/ 0 w 1803"/>
                  <a:gd name="T89" fmla="*/ 145 h 1303"/>
                  <a:gd name="T90" fmla="*/ 0 w 1803"/>
                  <a:gd name="T91" fmla="*/ 0 h 1303"/>
                  <a:gd name="T92" fmla="*/ 1803 w 1803"/>
                  <a:gd name="T93" fmla="*/ 0 h 1303"/>
                  <a:gd name="T94" fmla="*/ 1803 w 1803"/>
                  <a:gd name="T95" fmla="*/ 4 h 1303"/>
                  <a:gd name="T96" fmla="*/ 0 w 1803"/>
                  <a:gd name="T97" fmla="*/ 4 h 1303"/>
                  <a:gd name="T98" fmla="*/ 0 w 1803"/>
                  <a:gd name="T99" fmla="*/ 0 h 1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1803" h="1303">
                    <a:moveTo>
                      <a:pt x="0" y="1298"/>
                    </a:moveTo>
                    <a:lnTo>
                      <a:pt x="1803" y="1298"/>
                    </a:lnTo>
                    <a:lnTo>
                      <a:pt x="1803" y="1303"/>
                    </a:lnTo>
                    <a:lnTo>
                      <a:pt x="0" y="1303"/>
                    </a:lnTo>
                    <a:lnTo>
                      <a:pt x="0" y="1298"/>
                    </a:lnTo>
                    <a:close/>
                    <a:moveTo>
                      <a:pt x="0" y="1154"/>
                    </a:moveTo>
                    <a:lnTo>
                      <a:pt x="1803" y="1154"/>
                    </a:lnTo>
                    <a:lnTo>
                      <a:pt x="1803" y="1158"/>
                    </a:lnTo>
                    <a:lnTo>
                      <a:pt x="0" y="1158"/>
                    </a:lnTo>
                    <a:lnTo>
                      <a:pt x="0" y="1154"/>
                    </a:lnTo>
                    <a:close/>
                    <a:moveTo>
                      <a:pt x="0" y="1010"/>
                    </a:moveTo>
                    <a:lnTo>
                      <a:pt x="1803" y="1010"/>
                    </a:lnTo>
                    <a:lnTo>
                      <a:pt x="1803" y="1014"/>
                    </a:lnTo>
                    <a:lnTo>
                      <a:pt x="0" y="1014"/>
                    </a:lnTo>
                    <a:lnTo>
                      <a:pt x="0" y="1010"/>
                    </a:lnTo>
                    <a:close/>
                    <a:moveTo>
                      <a:pt x="0" y="866"/>
                    </a:moveTo>
                    <a:lnTo>
                      <a:pt x="1803" y="866"/>
                    </a:lnTo>
                    <a:lnTo>
                      <a:pt x="1803" y="870"/>
                    </a:lnTo>
                    <a:lnTo>
                      <a:pt x="0" y="870"/>
                    </a:lnTo>
                    <a:lnTo>
                      <a:pt x="0" y="866"/>
                    </a:lnTo>
                    <a:close/>
                    <a:moveTo>
                      <a:pt x="0" y="722"/>
                    </a:moveTo>
                    <a:lnTo>
                      <a:pt x="1803" y="722"/>
                    </a:lnTo>
                    <a:lnTo>
                      <a:pt x="1803" y="726"/>
                    </a:lnTo>
                    <a:lnTo>
                      <a:pt x="0" y="726"/>
                    </a:lnTo>
                    <a:lnTo>
                      <a:pt x="0" y="722"/>
                    </a:lnTo>
                    <a:close/>
                    <a:moveTo>
                      <a:pt x="0" y="577"/>
                    </a:moveTo>
                    <a:lnTo>
                      <a:pt x="1803" y="577"/>
                    </a:lnTo>
                    <a:lnTo>
                      <a:pt x="1803" y="581"/>
                    </a:lnTo>
                    <a:lnTo>
                      <a:pt x="0" y="581"/>
                    </a:lnTo>
                    <a:lnTo>
                      <a:pt x="0" y="577"/>
                    </a:lnTo>
                    <a:close/>
                    <a:moveTo>
                      <a:pt x="0" y="433"/>
                    </a:moveTo>
                    <a:lnTo>
                      <a:pt x="1803" y="433"/>
                    </a:lnTo>
                    <a:lnTo>
                      <a:pt x="1803" y="437"/>
                    </a:lnTo>
                    <a:lnTo>
                      <a:pt x="0" y="437"/>
                    </a:lnTo>
                    <a:lnTo>
                      <a:pt x="0" y="433"/>
                    </a:lnTo>
                    <a:close/>
                    <a:moveTo>
                      <a:pt x="0" y="289"/>
                    </a:moveTo>
                    <a:lnTo>
                      <a:pt x="1803" y="289"/>
                    </a:lnTo>
                    <a:lnTo>
                      <a:pt x="1803" y="293"/>
                    </a:lnTo>
                    <a:lnTo>
                      <a:pt x="0" y="293"/>
                    </a:lnTo>
                    <a:lnTo>
                      <a:pt x="0" y="289"/>
                    </a:lnTo>
                    <a:close/>
                    <a:moveTo>
                      <a:pt x="0" y="145"/>
                    </a:moveTo>
                    <a:lnTo>
                      <a:pt x="1803" y="145"/>
                    </a:lnTo>
                    <a:lnTo>
                      <a:pt x="1803" y="149"/>
                    </a:lnTo>
                    <a:lnTo>
                      <a:pt x="0" y="149"/>
                    </a:lnTo>
                    <a:lnTo>
                      <a:pt x="0" y="145"/>
                    </a:lnTo>
                    <a:close/>
                    <a:moveTo>
                      <a:pt x="0" y="0"/>
                    </a:moveTo>
                    <a:lnTo>
                      <a:pt x="1803" y="0"/>
                    </a:lnTo>
                    <a:lnTo>
                      <a:pt x="180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9D9D9"/>
              </a:solidFill>
              <a:ln w="1588" cap="flat">
                <a:solidFill>
                  <a:srgbClr val="D9D9D9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0" name="Freeform 345"/>
              <p:cNvSpPr>
                <a:spLocks noEditPoints="1"/>
              </p:cNvSpPr>
              <p:nvPr/>
            </p:nvSpPr>
            <p:spPr bwMode="auto">
              <a:xfrm>
                <a:off x="554" y="11694"/>
                <a:ext cx="4518" cy="2015"/>
              </a:xfrm>
              <a:custGeom>
                <a:avLst/>
                <a:gdLst>
                  <a:gd name="T0" fmla="*/ 0 w 20664"/>
                  <a:gd name="T1" fmla="*/ 24 h 15032"/>
                  <a:gd name="T2" fmla="*/ 24 w 20664"/>
                  <a:gd name="T3" fmla="*/ 0 h 15032"/>
                  <a:gd name="T4" fmla="*/ 20640 w 20664"/>
                  <a:gd name="T5" fmla="*/ 0 h 15032"/>
                  <a:gd name="T6" fmla="*/ 20664 w 20664"/>
                  <a:gd name="T7" fmla="*/ 24 h 15032"/>
                  <a:gd name="T8" fmla="*/ 20664 w 20664"/>
                  <a:gd name="T9" fmla="*/ 15008 h 15032"/>
                  <a:gd name="T10" fmla="*/ 20640 w 20664"/>
                  <a:gd name="T11" fmla="*/ 15032 h 15032"/>
                  <a:gd name="T12" fmla="*/ 24 w 20664"/>
                  <a:gd name="T13" fmla="*/ 15032 h 15032"/>
                  <a:gd name="T14" fmla="*/ 0 w 20664"/>
                  <a:gd name="T15" fmla="*/ 15008 h 15032"/>
                  <a:gd name="T16" fmla="*/ 0 w 20664"/>
                  <a:gd name="T17" fmla="*/ 24 h 15032"/>
                  <a:gd name="T18" fmla="*/ 48 w 20664"/>
                  <a:gd name="T19" fmla="*/ 15008 h 15032"/>
                  <a:gd name="T20" fmla="*/ 24 w 20664"/>
                  <a:gd name="T21" fmla="*/ 14984 h 15032"/>
                  <a:gd name="T22" fmla="*/ 20640 w 20664"/>
                  <a:gd name="T23" fmla="*/ 14984 h 15032"/>
                  <a:gd name="T24" fmla="*/ 20616 w 20664"/>
                  <a:gd name="T25" fmla="*/ 15008 h 15032"/>
                  <a:gd name="T26" fmla="*/ 20616 w 20664"/>
                  <a:gd name="T27" fmla="*/ 24 h 15032"/>
                  <a:gd name="T28" fmla="*/ 20640 w 20664"/>
                  <a:gd name="T29" fmla="*/ 48 h 15032"/>
                  <a:gd name="T30" fmla="*/ 24 w 20664"/>
                  <a:gd name="T31" fmla="*/ 48 h 15032"/>
                  <a:gd name="T32" fmla="*/ 48 w 20664"/>
                  <a:gd name="T33" fmla="*/ 24 h 15032"/>
                  <a:gd name="T34" fmla="*/ 48 w 20664"/>
                  <a:gd name="T35" fmla="*/ 15008 h 150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664" h="15032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20640" y="0"/>
                    </a:lnTo>
                    <a:cubicBezTo>
                      <a:pt x="20654" y="0"/>
                      <a:pt x="20664" y="11"/>
                      <a:pt x="20664" y="24"/>
                    </a:cubicBezTo>
                    <a:lnTo>
                      <a:pt x="20664" y="15008"/>
                    </a:lnTo>
                    <a:cubicBezTo>
                      <a:pt x="20664" y="15022"/>
                      <a:pt x="20654" y="15032"/>
                      <a:pt x="20640" y="15032"/>
                    </a:cubicBezTo>
                    <a:lnTo>
                      <a:pt x="24" y="15032"/>
                    </a:lnTo>
                    <a:cubicBezTo>
                      <a:pt x="11" y="15032"/>
                      <a:pt x="0" y="15022"/>
                      <a:pt x="0" y="15008"/>
                    </a:cubicBezTo>
                    <a:lnTo>
                      <a:pt x="0" y="24"/>
                    </a:lnTo>
                    <a:close/>
                    <a:moveTo>
                      <a:pt x="48" y="15008"/>
                    </a:moveTo>
                    <a:lnTo>
                      <a:pt x="24" y="14984"/>
                    </a:lnTo>
                    <a:lnTo>
                      <a:pt x="20640" y="14984"/>
                    </a:lnTo>
                    <a:lnTo>
                      <a:pt x="20616" y="15008"/>
                    </a:lnTo>
                    <a:lnTo>
                      <a:pt x="20616" y="24"/>
                    </a:lnTo>
                    <a:lnTo>
                      <a:pt x="20640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1500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1" name="Rectangle 346"/>
              <p:cNvSpPr>
                <a:spLocks noChangeArrowheads="1"/>
              </p:cNvSpPr>
              <p:nvPr/>
            </p:nvSpPr>
            <p:spPr bwMode="auto">
              <a:xfrm>
                <a:off x="616" y="12271"/>
                <a:ext cx="48" cy="1433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2" name="Rectangle 348"/>
              <p:cNvSpPr>
                <a:spLocks noChangeArrowheads="1"/>
              </p:cNvSpPr>
              <p:nvPr/>
            </p:nvSpPr>
            <p:spPr bwMode="auto">
              <a:xfrm>
                <a:off x="776" y="12348"/>
                <a:ext cx="50" cy="1356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3" name="Rectangle 350"/>
              <p:cNvSpPr>
                <a:spLocks noChangeArrowheads="1"/>
              </p:cNvSpPr>
              <p:nvPr/>
            </p:nvSpPr>
            <p:spPr bwMode="auto">
              <a:xfrm>
                <a:off x="936" y="13390"/>
                <a:ext cx="50" cy="314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4" name="Rectangle 352"/>
              <p:cNvSpPr>
                <a:spLocks noChangeArrowheads="1"/>
              </p:cNvSpPr>
              <p:nvPr/>
            </p:nvSpPr>
            <p:spPr bwMode="auto">
              <a:xfrm>
                <a:off x="1099" y="13393"/>
                <a:ext cx="50" cy="311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5" name="Rectangle 354"/>
              <p:cNvSpPr>
                <a:spLocks noChangeArrowheads="1"/>
              </p:cNvSpPr>
              <p:nvPr/>
            </p:nvSpPr>
            <p:spPr bwMode="auto">
              <a:xfrm>
                <a:off x="1259" y="13477"/>
                <a:ext cx="50" cy="227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6" name="Rectangle 356"/>
              <p:cNvSpPr>
                <a:spLocks noChangeArrowheads="1"/>
              </p:cNvSpPr>
              <p:nvPr/>
            </p:nvSpPr>
            <p:spPr bwMode="auto">
              <a:xfrm>
                <a:off x="1419" y="13480"/>
                <a:ext cx="53" cy="224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7" name="Rectangle 358"/>
              <p:cNvSpPr>
                <a:spLocks noChangeArrowheads="1"/>
              </p:cNvSpPr>
              <p:nvPr/>
            </p:nvSpPr>
            <p:spPr bwMode="auto">
              <a:xfrm>
                <a:off x="1581" y="13509"/>
                <a:ext cx="50" cy="195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8" name="Rectangle 360"/>
              <p:cNvSpPr>
                <a:spLocks noChangeArrowheads="1"/>
              </p:cNvSpPr>
              <p:nvPr/>
            </p:nvSpPr>
            <p:spPr bwMode="auto">
              <a:xfrm>
                <a:off x="1741" y="13630"/>
                <a:ext cx="50" cy="74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9" name="Rectangle 362"/>
              <p:cNvSpPr>
                <a:spLocks noChangeArrowheads="1"/>
              </p:cNvSpPr>
              <p:nvPr/>
            </p:nvSpPr>
            <p:spPr bwMode="auto">
              <a:xfrm>
                <a:off x="1901" y="13666"/>
                <a:ext cx="53" cy="38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0" name="Rectangle 364"/>
              <p:cNvSpPr>
                <a:spLocks noChangeArrowheads="1"/>
              </p:cNvSpPr>
              <p:nvPr/>
            </p:nvSpPr>
            <p:spPr bwMode="auto">
              <a:xfrm>
                <a:off x="2064" y="13678"/>
                <a:ext cx="50" cy="26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1" name="Rectangle 366"/>
              <p:cNvSpPr>
                <a:spLocks noChangeArrowheads="1"/>
              </p:cNvSpPr>
              <p:nvPr/>
            </p:nvSpPr>
            <p:spPr bwMode="auto">
              <a:xfrm>
                <a:off x="2224" y="13678"/>
                <a:ext cx="50" cy="26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2" name="Rectangle 368"/>
              <p:cNvSpPr>
                <a:spLocks noChangeArrowheads="1"/>
              </p:cNvSpPr>
              <p:nvPr/>
            </p:nvSpPr>
            <p:spPr bwMode="auto">
              <a:xfrm>
                <a:off x="2384" y="13678"/>
                <a:ext cx="53" cy="26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3" name="Rectangle 370"/>
              <p:cNvSpPr>
                <a:spLocks noChangeArrowheads="1"/>
              </p:cNvSpPr>
              <p:nvPr/>
            </p:nvSpPr>
            <p:spPr bwMode="auto">
              <a:xfrm>
                <a:off x="2546" y="13687"/>
                <a:ext cx="50" cy="17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4" name="Rectangle 372"/>
              <p:cNvSpPr>
                <a:spLocks noChangeArrowheads="1"/>
              </p:cNvSpPr>
              <p:nvPr/>
            </p:nvSpPr>
            <p:spPr bwMode="auto">
              <a:xfrm>
                <a:off x="2706" y="13701"/>
                <a:ext cx="50" cy="3"/>
              </a:xfrm>
              <a:prstGeom prst="rect">
                <a:avLst/>
              </a:prstGeom>
              <a:solidFill>
                <a:srgbClr val="FF99FF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5" name="Rectangle 374"/>
              <p:cNvSpPr>
                <a:spLocks noChangeArrowheads="1"/>
              </p:cNvSpPr>
              <p:nvPr/>
            </p:nvSpPr>
            <p:spPr bwMode="auto">
              <a:xfrm>
                <a:off x="2866" y="13366"/>
                <a:ext cx="53" cy="338"/>
              </a:xfrm>
              <a:prstGeom prst="rect">
                <a:avLst/>
              </a:prstGeom>
              <a:solidFill>
                <a:srgbClr val="CCFF66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6" name="Rectangle 376"/>
              <p:cNvSpPr>
                <a:spLocks noChangeArrowheads="1"/>
              </p:cNvSpPr>
              <p:nvPr/>
            </p:nvSpPr>
            <p:spPr bwMode="auto">
              <a:xfrm>
                <a:off x="3029" y="13379"/>
                <a:ext cx="50" cy="325"/>
              </a:xfrm>
              <a:prstGeom prst="rect">
                <a:avLst/>
              </a:prstGeom>
              <a:solidFill>
                <a:srgbClr val="CCFF66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7" name="Rectangle 378"/>
              <p:cNvSpPr>
                <a:spLocks noChangeArrowheads="1"/>
              </p:cNvSpPr>
              <p:nvPr/>
            </p:nvSpPr>
            <p:spPr bwMode="auto">
              <a:xfrm>
                <a:off x="3189" y="13537"/>
                <a:ext cx="50" cy="167"/>
              </a:xfrm>
              <a:prstGeom prst="rect">
                <a:avLst/>
              </a:prstGeom>
              <a:solidFill>
                <a:srgbClr val="CCFF66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8" name="Rectangle 380"/>
              <p:cNvSpPr>
                <a:spLocks noChangeArrowheads="1"/>
              </p:cNvSpPr>
              <p:nvPr/>
            </p:nvSpPr>
            <p:spPr bwMode="auto">
              <a:xfrm>
                <a:off x="3351" y="13670"/>
                <a:ext cx="50" cy="34"/>
              </a:xfrm>
              <a:prstGeom prst="rect">
                <a:avLst/>
              </a:prstGeom>
              <a:solidFill>
                <a:srgbClr val="CCFF66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9" name="Freeform 381"/>
              <p:cNvSpPr>
                <a:spLocks noEditPoints="1"/>
              </p:cNvSpPr>
              <p:nvPr/>
            </p:nvSpPr>
            <p:spPr bwMode="auto">
              <a:xfrm>
                <a:off x="3344" y="13666"/>
                <a:ext cx="63" cy="43"/>
              </a:xfrm>
              <a:custGeom>
                <a:avLst/>
                <a:gdLst>
                  <a:gd name="T0" fmla="*/ 0 w 560"/>
                  <a:gd name="T1" fmla="*/ 48 h 624"/>
                  <a:gd name="T2" fmla="*/ 48 w 560"/>
                  <a:gd name="T3" fmla="*/ 0 h 624"/>
                  <a:gd name="T4" fmla="*/ 512 w 560"/>
                  <a:gd name="T5" fmla="*/ 0 h 624"/>
                  <a:gd name="T6" fmla="*/ 560 w 560"/>
                  <a:gd name="T7" fmla="*/ 48 h 624"/>
                  <a:gd name="T8" fmla="*/ 560 w 560"/>
                  <a:gd name="T9" fmla="*/ 576 h 624"/>
                  <a:gd name="T10" fmla="*/ 512 w 560"/>
                  <a:gd name="T11" fmla="*/ 624 h 624"/>
                  <a:gd name="T12" fmla="*/ 48 w 560"/>
                  <a:gd name="T13" fmla="*/ 624 h 624"/>
                  <a:gd name="T14" fmla="*/ 0 w 560"/>
                  <a:gd name="T15" fmla="*/ 576 h 624"/>
                  <a:gd name="T16" fmla="*/ 0 w 560"/>
                  <a:gd name="T17" fmla="*/ 48 h 624"/>
                  <a:gd name="T18" fmla="*/ 96 w 560"/>
                  <a:gd name="T19" fmla="*/ 576 h 624"/>
                  <a:gd name="T20" fmla="*/ 48 w 560"/>
                  <a:gd name="T21" fmla="*/ 528 h 624"/>
                  <a:gd name="T22" fmla="*/ 512 w 560"/>
                  <a:gd name="T23" fmla="*/ 528 h 624"/>
                  <a:gd name="T24" fmla="*/ 464 w 560"/>
                  <a:gd name="T25" fmla="*/ 576 h 624"/>
                  <a:gd name="T26" fmla="*/ 464 w 560"/>
                  <a:gd name="T27" fmla="*/ 48 h 624"/>
                  <a:gd name="T28" fmla="*/ 512 w 560"/>
                  <a:gd name="T29" fmla="*/ 96 h 624"/>
                  <a:gd name="T30" fmla="*/ 48 w 560"/>
                  <a:gd name="T31" fmla="*/ 96 h 624"/>
                  <a:gd name="T32" fmla="*/ 96 w 560"/>
                  <a:gd name="T33" fmla="*/ 48 h 624"/>
                  <a:gd name="T34" fmla="*/ 96 w 560"/>
                  <a:gd name="T35" fmla="*/ 576 h 6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60" h="624">
                    <a:moveTo>
                      <a:pt x="0" y="48"/>
                    </a:moveTo>
                    <a:cubicBezTo>
                      <a:pt x="0" y="22"/>
                      <a:pt x="22" y="0"/>
                      <a:pt x="48" y="0"/>
                    </a:cubicBezTo>
                    <a:lnTo>
                      <a:pt x="512" y="0"/>
                    </a:lnTo>
                    <a:cubicBezTo>
                      <a:pt x="539" y="0"/>
                      <a:pt x="560" y="22"/>
                      <a:pt x="560" y="48"/>
                    </a:cubicBezTo>
                    <a:lnTo>
                      <a:pt x="560" y="576"/>
                    </a:lnTo>
                    <a:cubicBezTo>
                      <a:pt x="560" y="603"/>
                      <a:pt x="539" y="624"/>
                      <a:pt x="512" y="624"/>
                    </a:cubicBezTo>
                    <a:lnTo>
                      <a:pt x="48" y="624"/>
                    </a:lnTo>
                    <a:cubicBezTo>
                      <a:pt x="22" y="624"/>
                      <a:pt x="0" y="603"/>
                      <a:pt x="0" y="576"/>
                    </a:cubicBezTo>
                    <a:lnTo>
                      <a:pt x="0" y="48"/>
                    </a:lnTo>
                    <a:close/>
                    <a:moveTo>
                      <a:pt x="96" y="576"/>
                    </a:moveTo>
                    <a:lnTo>
                      <a:pt x="48" y="528"/>
                    </a:lnTo>
                    <a:lnTo>
                      <a:pt x="512" y="528"/>
                    </a:lnTo>
                    <a:lnTo>
                      <a:pt x="464" y="576"/>
                    </a:lnTo>
                    <a:lnTo>
                      <a:pt x="464" y="48"/>
                    </a:lnTo>
                    <a:lnTo>
                      <a:pt x="512" y="96"/>
                    </a:lnTo>
                    <a:lnTo>
                      <a:pt x="48" y="96"/>
                    </a:lnTo>
                    <a:lnTo>
                      <a:pt x="96" y="48"/>
                    </a:lnTo>
                    <a:lnTo>
                      <a:pt x="96" y="57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0" name="Rectangle 382"/>
              <p:cNvSpPr>
                <a:spLocks noChangeArrowheads="1"/>
              </p:cNvSpPr>
              <p:nvPr/>
            </p:nvSpPr>
            <p:spPr bwMode="auto">
              <a:xfrm>
                <a:off x="3511" y="13701"/>
                <a:ext cx="50" cy="3"/>
              </a:xfrm>
              <a:prstGeom prst="rect">
                <a:avLst/>
              </a:prstGeom>
              <a:solidFill>
                <a:srgbClr val="CCFF66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1" name="Rectangle 384"/>
              <p:cNvSpPr>
                <a:spLocks noChangeArrowheads="1"/>
              </p:cNvSpPr>
              <p:nvPr/>
            </p:nvSpPr>
            <p:spPr bwMode="auto">
              <a:xfrm>
                <a:off x="3671" y="11833"/>
                <a:ext cx="53" cy="1871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2" name="Rectangle 386"/>
              <p:cNvSpPr>
                <a:spLocks noChangeArrowheads="1"/>
              </p:cNvSpPr>
              <p:nvPr/>
            </p:nvSpPr>
            <p:spPr bwMode="auto">
              <a:xfrm>
                <a:off x="3834" y="12166"/>
                <a:ext cx="50" cy="1538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3" name="Rectangle 388"/>
              <p:cNvSpPr>
                <a:spLocks noChangeArrowheads="1"/>
              </p:cNvSpPr>
              <p:nvPr/>
            </p:nvSpPr>
            <p:spPr bwMode="auto">
              <a:xfrm>
                <a:off x="3994" y="13557"/>
                <a:ext cx="50" cy="147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4" name="Rectangle 390"/>
              <p:cNvSpPr>
                <a:spLocks noChangeArrowheads="1"/>
              </p:cNvSpPr>
              <p:nvPr/>
            </p:nvSpPr>
            <p:spPr bwMode="auto">
              <a:xfrm>
                <a:off x="4154" y="13670"/>
                <a:ext cx="53" cy="34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5" name="Rectangle 392"/>
              <p:cNvSpPr>
                <a:spLocks noChangeArrowheads="1"/>
              </p:cNvSpPr>
              <p:nvPr/>
            </p:nvSpPr>
            <p:spPr bwMode="auto">
              <a:xfrm>
                <a:off x="4316" y="13676"/>
                <a:ext cx="50" cy="28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6" name="Rectangle 394"/>
              <p:cNvSpPr>
                <a:spLocks noChangeArrowheads="1"/>
              </p:cNvSpPr>
              <p:nvPr/>
            </p:nvSpPr>
            <p:spPr bwMode="auto">
              <a:xfrm>
                <a:off x="4476" y="13685"/>
                <a:ext cx="50" cy="19"/>
              </a:xfrm>
              <a:prstGeom prst="rect">
                <a:avLst/>
              </a:prstGeom>
              <a:solidFill>
                <a:srgbClr val="FF99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7" name="Rectangle 396"/>
              <p:cNvSpPr>
                <a:spLocks noChangeArrowheads="1"/>
              </p:cNvSpPr>
              <p:nvPr/>
            </p:nvSpPr>
            <p:spPr bwMode="auto">
              <a:xfrm>
                <a:off x="4636" y="13695"/>
                <a:ext cx="53" cy="9"/>
              </a:xfrm>
              <a:prstGeom prst="rect">
                <a:avLst/>
              </a:prstGeom>
              <a:solidFill>
                <a:srgbClr val="FFCC66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8" name="Rectangle 398"/>
              <p:cNvSpPr>
                <a:spLocks noChangeArrowheads="1"/>
              </p:cNvSpPr>
              <p:nvPr/>
            </p:nvSpPr>
            <p:spPr bwMode="auto">
              <a:xfrm>
                <a:off x="4799" y="13698"/>
                <a:ext cx="50" cy="6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69" name="Rectangle 400"/>
              <p:cNvSpPr>
                <a:spLocks noChangeArrowheads="1"/>
              </p:cNvSpPr>
              <p:nvPr/>
            </p:nvSpPr>
            <p:spPr bwMode="auto">
              <a:xfrm>
                <a:off x="4959" y="13703"/>
                <a:ext cx="50" cy="1"/>
              </a:xfrm>
              <a:prstGeom prst="rect">
                <a:avLst/>
              </a:prstGeom>
              <a:solidFill>
                <a:srgbClr val="4F81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0" name="Freeform 401"/>
              <p:cNvSpPr>
                <a:spLocks noEditPoints="1"/>
              </p:cNvSpPr>
              <p:nvPr/>
            </p:nvSpPr>
            <p:spPr bwMode="auto">
              <a:xfrm>
                <a:off x="4954" y="13700"/>
                <a:ext cx="60" cy="9"/>
              </a:xfrm>
              <a:custGeom>
                <a:avLst/>
                <a:gdLst>
                  <a:gd name="T0" fmla="*/ 0 w 280"/>
                  <a:gd name="T1" fmla="*/ 24 h 64"/>
                  <a:gd name="T2" fmla="*/ 24 w 280"/>
                  <a:gd name="T3" fmla="*/ 0 h 64"/>
                  <a:gd name="T4" fmla="*/ 256 w 280"/>
                  <a:gd name="T5" fmla="*/ 0 h 64"/>
                  <a:gd name="T6" fmla="*/ 280 w 280"/>
                  <a:gd name="T7" fmla="*/ 24 h 64"/>
                  <a:gd name="T8" fmla="*/ 280 w 280"/>
                  <a:gd name="T9" fmla="*/ 40 h 64"/>
                  <a:gd name="T10" fmla="*/ 256 w 280"/>
                  <a:gd name="T11" fmla="*/ 64 h 64"/>
                  <a:gd name="T12" fmla="*/ 24 w 280"/>
                  <a:gd name="T13" fmla="*/ 64 h 64"/>
                  <a:gd name="T14" fmla="*/ 0 w 280"/>
                  <a:gd name="T15" fmla="*/ 40 h 64"/>
                  <a:gd name="T16" fmla="*/ 0 w 280"/>
                  <a:gd name="T17" fmla="*/ 24 h 64"/>
                  <a:gd name="T18" fmla="*/ 48 w 280"/>
                  <a:gd name="T19" fmla="*/ 40 h 64"/>
                  <a:gd name="T20" fmla="*/ 24 w 280"/>
                  <a:gd name="T21" fmla="*/ 16 h 64"/>
                  <a:gd name="T22" fmla="*/ 256 w 280"/>
                  <a:gd name="T23" fmla="*/ 16 h 64"/>
                  <a:gd name="T24" fmla="*/ 232 w 280"/>
                  <a:gd name="T25" fmla="*/ 40 h 64"/>
                  <a:gd name="T26" fmla="*/ 232 w 280"/>
                  <a:gd name="T27" fmla="*/ 24 h 64"/>
                  <a:gd name="T28" fmla="*/ 256 w 280"/>
                  <a:gd name="T29" fmla="*/ 48 h 64"/>
                  <a:gd name="T30" fmla="*/ 24 w 280"/>
                  <a:gd name="T31" fmla="*/ 48 h 64"/>
                  <a:gd name="T32" fmla="*/ 48 w 280"/>
                  <a:gd name="T33" fmla="*/ 24 h 64"/>
                  <a:gd name="T34" fmla="*/ 48 w 280"/>
                  <a:gd name="T35" fmla="*/ 4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80" h="64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256" y="0"/>
                    </a:lnTo>
                    <a:cubicBezTo>
                      <a:pt x="270" y="0"/>
                      <a:pt x="280" y="11"/>
                      <a:pt x="280" y="24"/>
                    </a:cubicBezTo>
                    <a:lnTo>
                      <a:pt x="280" y="40"/>
                    </a:lnTo>
                    <a:cubicBezTo>
                      <a:pt x="280" y="54"/>
                      <a:pt x="270" y="64"/>
                      <a:pt x="256" y="64"/>
                    </a:cubicBezTo>
                    <a:lnTo>
                      <a:pt x="24" y="64"/>
                    </a:lnTo>
                    <a:cubicBezTo>
                      <a:pt x="11" y="64"/>
                      <a:pt x="0" y="54"/>
                      <a:pt x="0" y="40"/>
                    </a:cubicBezTo>
                    <a:lnTo>
                      <a:pt x="0" y="24"/>
                    </a:lnTo>
                    <a:close/>
                    <a:moveTo>
                      <a:pt x="48" y="40"/>
                    </a:moveTo>
                    <a:lnTo>
                      <a:pt x="24" y="16"/>
                    </a:lnTo>
                    <a:lnTo>
                      <a:pt x="256" y="16"/>
                    </a:lnTo>
                    <a:lnTo>
                      <a:pt x="232" y="40"/>
                    </a:lnTo>
                    <a:lnTo>
                      <a:pt x="232" y="24"/>
                    </a:lnTo>
                    <a:lnTo>
                      <a:pt x="256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4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71" name="Rectangle 402"/>
              <p:cNvSpPr>
                <a:spLocks noChangeArrowheads="1"/>
              </p:cNvSpPr>
              <p:nvPr/>
            </p:nvSpPr>
            <p:spPr bwMode="auto">
              <a:xfrm>
                <a:off x="371" y="13651"/>
                <a:ext cx="81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Rectangle 403"/>
              <p:cNvSpPr>
                <a:spLocks noChangeArrowheads="1"/>
              </p:cNvSpPr>
              <p:nvPr/>
            </p:nvSpPr>
            <p:spPr bwMode="auto">
              <a:xfrm>
                <a:off x="239" y="13427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Rectangle 404"/>
              <p:cNvSpPr>
                <a:spLocks noChangeArrowheads="1"/>
              </p:cNvSpPr>
              <p:nvPr/>
            </p:nvSpPr>
            <p:spPr bwMode="auto">
              <a:xfrm>
                <a:off x="239" y="13205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Rectangle 405"/>
              <p:cNvSpPr>
                <a:spLocks noChangeArrowheads="1"/>
              </p:cNvSpPr>
              <p:nvPr/>
            </p:nvSpPr>
            <p:spPr bwMode="auto">
              <a:xfrm>
                <a:off x="239" y="12982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Rectangle 406"/>
              <p:cNvSpPr>
                <a:spLocks noChangeArrowheads="1"/>
              </p:cNvSpPr>
              <p:nvPr/>
            </p:nvSpPr>
            <p:spPr bwMode="auto">
              <a:xfrm>
                <a:off x="239" y="12761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Rectangle 407"/>
              <p:cNvSpPr>
                <a:spLocks noChangeArrowheads="1"/>
              </p:cNvSpPr>
              <p:nvPr/>
            </p:nvSpPr>
            <p:spPr bwMode="auto">
              <a:xfrm>
                <a:off x="239" y="12535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Rectangle 408"/>
              <p:cNvSpPr>
                <a:spLocks noChangeArrowheads="1"/>
              </p:cNvSpPr>
              <p:nvPr/>
            </p:nvSpPr>
            <p:spPr bwMode="auto">
              <a:xfrm>
                <a:off x="239" y="12312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8" name="Rectangle 409"/>
              <p:cNvSpPr>
                <a:spLocks noChangeArrowheads="1"/>
              </p:cNvSpPr>
              <p:nvPr/>
            </p:nvSpPr>
            <p:spPr bwMode="auto">
              <a:xfrm>
                <a:off x="239" y="12090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9" name="Rectangle 410"/>
              <p:cNvSpPr>
                <a:spLocks noChangeArrowheads="1"/>
              </p:cNvSpPr>
              <p:nvPr/>
            </p:nvSpPr>
            <p:spPr bwMode="auto">
              <a:xfrm>
                <a:off x="239" y="11866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Rectangle 411"/>
              <p:cNvSpPr>
                <a:spLocks noChangeArrowheads="1"/>
              </p:cNvSpPr>
              <p:nvPr/>
            </p:nvSpPr>
            <p:spPr bwMode="auto">
              <a:xfrm>
                <a:off x="239" y="11643"/>
                <a:ext cx="242" cy="1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0</a:t>
                </a:r>
                <a:endParaRPr kumimoji="0" lang="zh-CN" altLang="zh-CN" sz="8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文本框 206"/>
              <p:cNvSpPr txBox="1"/>
              <p:nvPr/>
            </p:nvSpPr>
            <p:spPr>
              <a:xfrm rot="10800000">
                <a:off x="-122" y="12258"/>
                <a:ext cx="484" cy="123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 gene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08" name="文本框 207"/>
            <p:cNvSpPr txBox="1"/>
            <p:nvPr/>
          </p:nvSpPr>
          <p:spPr>
            <a:xfrm>
              <a:off x="-21" y="5887"/>
              <a:ext cx="4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1795" y="1110"/>
              <a:ext cx="1303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L vs. CK</a:t>
              </a:r>
            </a:p>
          </p:txBody>
        </p:sp>
        <p:sp>
          <p:nvSpPr>
            <p:cNvPr id="216" name="文本框 215"/>
            <p:cNvSpPr txBox="1"/>
            <p:nvPr/>
          </p:nvSpPr>
          <p:spPr>
            <a:xfrm rot="12694542">
              <a:off x="347" y="7822"/>
              <a:ext cx="481" cy="136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abolic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文本框 216"/>
            <p:cNvSpPr txBox="1"/>
            <p:nvPr/>
          </p:nvSpPr>
          <p:spPr>
            <a:xfrm rot="12694542">
              <a:off x="631" y="7779"/>
              <a:ext cx="481" cy="219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gulation of biological proces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文本框 217"/>
            <p:cNvSpPr txBox="1"/>
            <p:nvPr/>
          </p:nvSpPr>
          <p:spPr>
            <a:xfrm>
              <a:off x="2171" y="5589"/>
              <a:ext cx="2098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L-TMV vs. TMV</a:t>
              </a:r>
            </a:p>
          </p:txBody>
        </p:sp>
        <p:sp>
          <p:nvSpPr>
            <p:cNvPr id="219" name="文本框 218"/>
            <p:cNvSpPr txBox="1"/>
            <p:nvPr/>
          </p:nvSpPr>
          <p:spPr>
            <a:xfrm>
              <a:off x="2164" y="10505"/>
              <a:ext cx="2098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SL-TMV vs. SL</a:t>
              </a:r>
            </a:p>
          </p:txBody>
        </p:sp>
        <p:pic>
          <p:nvPicPr>
            <p:cNvPr id="222" name="图片 22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7" t="3157" r="8543" b="5088"/>
            <a:stretch>
              <a:fillRect/>
            </a:stretch>
          </p:blipFill>
          <p:spPr>
            <a:xfrm>
              <a:off x="8189" y="1308"/>
              <a:ext cx="1923" cy="3376"/>
            </a:xfrm>
            <a:prstGeom prst="rect">
              <a:avLst/>
            </a:prstGeom>
          </p:spPr>
        </p:pic>
        <p:sp>
          <p:nvSpPr>
            <p:cNvPr id="223" name="文本框 222"/>
            <p:cNvSpPr txBox="1"/>
            <p:nvPr/>
          </p:nvSpPr>
          <p:spPr>
            <a:xfrm>
              <a:off x="7121" y="1036"/>
              <a:ext cx="317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 vs. CK(total): KEGG enrichment top 20 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5117" y="1272"/>
              <a:ext cx="319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processing in endoplasmic reticulu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文本框 224"/>
            <p:cNvSpPr txBox="1"/>
            <p:nvPr/>
          </p:nvSpPr>
          <p:spPr>
            <a:xfrm>
              <a:off x="5776" y="1440"/>
              <a:ext cx="2537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 hormone signal transduc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文本框 225"/>
            <p:cNvSpPr txBox="1"/>
            <p:nvPr/>
          </p:nvSpPr>
          <p:spPr>
            <a:xfrm>
              <a:off x="6192" y="1594"/>
              <a:ext cx="212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of amino acid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6733" y="1765"/>
              <a:ext cx="158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n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5512" y="1928"/>
              <a:ext cx="280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osynthesis of unsaturated fatty acid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文本框 228"/>
            <p:cNvSpPr txBox="1"/>
            <p:nvPr/>
          </p:nvSpPr>
          <p:spPr>
            <a:xfrm>
              <a:off x="6053" y="2095"/>
              <a:ext cx="2267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enylpropanoid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iosynth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文本框 229"/>
            <p:cNvSpPr txBox="1"/>
            <p:nvPr/>
          </p:nvSpPr>
          <p:spPr>
            <a:xfrm>
              <a:off x="6809" y="2244"/>
              <a:ext cx="151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lfur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文本框 230"/>
            <p:cNvSpPr txBox="1"/>
            <p:nvPr/>
          </p:nvSpPr>
          <p:spPr>
            <a:xfrm>
              <a:off x="6450" y="2411"/>
              <a:ext cx="1863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otenoid biosynth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文本框 231"/>
            <p:cNvSpPr txBox="1"/>
            <p:nvPr/>
          </p:nvSpPr>
          <p:spPr>
            <a:xfrm>
              <a:off x="5117" y="2573"/>
              <a:ext cx="319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rbon fixation in photosynthetic organism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文本框 232"/>
            <p:cNvSpPr txBox="1"/>
            <p:nvPr/>
          </p:nvSpPr>
          <p:spPr>
            <a:xfrm>
              <a:off x="6656" y="2741"/>
              <a:ext cx="167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e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文本框 233"/>
            <p:cNvSpPr txBox="1"/>
            <p:nvPr/>
          </p:nvSpPr>
          <p:spPr>
            <a:xfrm>
              <a:off x="5875" y="2917"/>
              <a:ext cx="246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pha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inolenic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文本框 234"/>
            <p:cNvSpPr txBox="1"/>
            <p:nvPr/>
          </p:nvSpPr>
          <p:spPr>
            <a:xfrm>
              <a:off x="6370" y="3084"/>
              <a:ext cx="1955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oleic acid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文本框 235"/>
            <p:cNvSpPr txBox="1"/>
            <p:nvPr/>
          </p:nvSpPr>
          <p:spPr>
            <a:xfrm>
              <a:off x="6280" y="3247"/>
              <a:ext cx="202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eptomycin biosynth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文本框 236"/>
            <p:cNvSpPr txBox="1"/>
            <p:nvPr/>
          </p:nvSpPr>
          <p:spPr>
            <a:xfrm>
              <a:off x="6005" y="3403"/>
              <a:ext cx="2315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rch and sucrose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文本框 237"/>
            <p:cNvSpPr txBox="1"/>
            <p:nvPr/>
          </p:nvSpPr>
          <p:spPr>
            <a:xfrm>
              <a:off x="5209" y="3576"/>
              <a:ext cx="3133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line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ucine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isoleucine biosynth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文本框 238"/>
            <p:cNvSpPr txBox="1"/>
            <p:nvPr/>
          </p:nvSpPr>
          <p:spPr>
            <a:xfrm>
              <a:off x="5610" y="3743"/>
              <a:ext cx="2745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steine and methionine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文本框 239"/>
            <p:cNvSpPr txBox="1"/>
            <p:nvPr/>
          </p:nvSpPr>
          <p:spPr>
            <a:xfrm>
              <a:off x="5320" y="3904"/>
              <a:ext cx="300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, serine and threonine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文本框 240"/>
            <p:cNvSpPr txBox="1"/>
            <p:nvPr/>
          </p:nvSpPr>
          <p:spPr>
            <a:xfrm>
              <a:off x="6638" y="4064"/>
              <a:ext cx="166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ty acid elongatio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文本框 241"/>
            <p:cNvSpPr txBox="1"/>
            <p:nvPr/>
          </p:nvSpPr>
          <p:spPr>
            <a:xfrm>
              <a:off x="6581" y="4231"/>
              <a:ext cx="173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lactose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tabolism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文本框 242"/>
            <p:cNvSpPr txBox="1"/>
            <p:nvPr/>
          </p:nvSpPr>
          <p:spPr>
            <a:xfrm>
              <a:off x="6077" y="4411"/>
              <a:ext cx="223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olysis / Gluconeogenesi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文本框 243"/>
            <p:cNvSpPr txBox="1"/>
            <p:nvPr/>
          </p:nvSpPr>
          <p:spPr>
            <a:xfrm>
              <a:off x="8182" y="4621"/>
              <a:ext cx="57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文本框 244"/>
            <p:cNvSpPr txBox="1"/>
            <p:nvPr/>
          </p:nvSpPr>
          <p:spPr>
            <a:xfrm>
              <a:off x="8710" y="4621"/>
              <a:ext cx="57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文本框 245"/>
            <p:cNvSpPr txBox="1"/>
            <p:nvPr/>
          </p:nvSpPr>
          <p:spPr>
            <a:xfrm>
              <a:off x="9262" y="4618"/>
              <a:ext cx="571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.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文本框 246"/>
            <p:cNvSpPr txBox="1"/>
            <p:nvPr/>
          </p:nvSpPr>
          <p:spPr>
            <a:xfrm>
              <a:off x="9732" y="4605"/>
              <a:ext cx="64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文本框 247"/>
            <p:cNvSpPr txBox="1"/>
            <p:nvPr/>
          </p:nvSpPr>
          <p:spPr>
            <a:xfrm>
              <a:off x="8497" y="4810"/>
              <a:ext cx="152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richment Score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矩形 248"/>
            <p:cNvSpPr/>
            <p:nvPr/>
          </p:nvSpPr>
          <p:spPr>
            <a:xfrm>
              <a:off x="5511" y="1501"/>
              <a:ext cx="2670" cy="1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0" name="文本框 249"/>
            <p:cNvSpPr txBox="1"/>
            <p:nvPr/>
          </p:nvSpPr>
          <p:spPr>
            <a:xfrm>
              <a:off x="5335" y="763"/>
              <a:ext cx="364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b.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文本框 250"/>
            <p:cNvSpPr txBox="1"/>
            <p:nvPr/>
          </p:nvSpPr>
          <p:spPr>
            <a:xfrm>
              <a:off x="144" y="10742"/>
              <a:ext cx="42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e.</a:t>
              </a:r>
            </a:p>
          </p:txBody>
        </p:sp>
        <p:grpSp>
          <p:nvGrpSpPr>
            <p:cNvPr id="252" name="组合 251"/>
            <p:cNvGrpSpPr/>
            <p:nvPr/>
          </p:nvGrpSpPr>
          <p:grpSpPr>
            <a:xfrm>
              <a:off x="5685" y="5583"/>
              <a:ext cx="4964" cy="4434"/>
              <a:chOff x="3671624" y="3887296"/>
              <a:chExt cx="3152020" cy="2815403"/>
            </a:xfrm>
          </p:grpSpPr>
          <p:pic>
            <p:nvPicPr>
              <p:cNvPr id="253" name="图片 25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567" t="3714" r="1081" b="4877"/>
              <a:stretch>
                <a:fillRect/>
              </a:stretch>
            </p:blipFill>
            <p:spPr>
              <a:xfrm>
                <a:off x="5667469" y="4096301"/>
                <a:ext cx="1156175" cy="2341498"/>
              </a:xfrm>
              <a:prstGeom prst="rect">
                <a:avLst/>
              </a:prstGeom>
            </p:spPr>
          </p:pic>
          <p:sp>
            <p:nvSpPr>
              <p:cNvPr id="254" name="文本框 253"/>
              <p:cNvSpPr txBox="1"/>
              <p:nvPr/>
            </p:nvSpPr>
            <p:spPr>
              <a:xfrm>
                <a:off x="4314925" y="3887296"/>
                <a:ext cx="2366532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-TMV VS TMV(total):KEGG enrichment top 20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文本框 254"/>
              <p:cNvSpPr txBox="1"/>
              <p:nvPr/>
            </p:nvSpPr>
            <p:spPr>
              <a:xfrm>
                <a:off x="5714955" y="6488704"/>
                <a:ext cx="95569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richment Scor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文本框 255"/>
              <p:cNvSpPr txBox="1"/>
              <p:nvPr/>
            </p:nvSpPr>
            <p:spPr>
              <a:xfrm>
                <a:off x="5626635" y="6371974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文本框 256"/>
              <p:cNvSpPr txBox="1"/>
              <p:nvPr/>
            </p:nvSpPr>
            <p:spPr>
              <a:xfrm>
                <a:off x="5861982" y="6371896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文本框 257"/>
              <p:cNvSpPr txBox="1"/>
              <p:nvPr/>
            </p:nvSpPr>
            <p:spPr>
              <a:xfrm>
                <a:off x="6104885" y="6365478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文本框 258"/>
              <p:cNvSpPr txBox="1"/>
              <p:nvPr/>
            </p:nvSpPr>
            <p:spPr>
              <a:xfrm>
                <a:off x="6349545" y="6365658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文本框 259"/>
              <p:cNvSpPr txBox="1"/>
              <p:nvPr/>
            </p:nvSpPr>
            <p:spPr>
              <a:xfrm>
                <a:off x="5028546" y="4050050"/>
                <a:ext cx="717146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 junc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文本框 260"/>
              <p:cNvSpPr txBox="1"/>
              <p:nvPr/>
            </p:nvSpPr>
            <p:spPr>
              <a:xfrm>
                <a:off x="5148352" y="4172320"/>
                <a:ext cx="63279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pto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文本框 261"/>
              <p:cNvSpPr txBox="1"/>
              <p:nvPr/>
            </p:nvSpPr>
            <p:spPr>
              <a:xfrm>
                <a:off x="4637134" y="4299668"/>
                <a:ext cx="1122315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3 signaling pathwa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文本框 262"/>
              <p:cNvSpPr txBox="1"/>
              <p:nvPr/>
            </p:nvSpPr>
            <p:spPr>
              <a:xfrm>
                <a:off x="4932455" y="4407390"/>
                <a:ext cx="813237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ocyte meio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文本框 263"/>
              <p:cNvSpPr txBox="1"/>
              <p:nvPr/>
            </p:nvSpPr>
            <p:spPr>
              <a:xfrm>
                <a:off x="4939593" y="4520423"/>
                <a:ext cx="819856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iosis - yeas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文本框 264"/>
              <p:cNvSpPr txBox="1"/>
              <p:nvPr/>
            </p:nvSpPr>
            <p:spPr>
              <a:xfrm>
                <a:off x="4854075" y="4633456"/>
                <a:ext cx="900893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cycle - yeas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文本框 265"/>
              <p:cNvSpPr txBox="1"/>
              <p:nvPr/>
            </p:nvSpPr>
            <p:spPr>
              <a:xfrm>
                <a:off x="5148352" y="4747273"/>
                <a:ext cx="614542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cycl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文本框 266"/>
              <p:cNvSpPr txBox="1"/>
              <p:nvPr/>
            </p:nvSpPr>
            <p:spPr>
              <a:xfrm>
                <a:off x="4167552" y="4854845"/>
                <a:ext cx="159467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hormone signal transduc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文本框 267"/>
              <p:cNvSpPr txBox="1"/>
              <p:nvPr/>
            </p:nvSpPr>
            <p:spPr>
              <a:xfrm>
                <a:off x="4556252" y="4969787"/>
                <a:ext cx="1192099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xO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ignaling pathwa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9" name="文本框 268"/>
              <p:cNvSpPr txBox="1"/>
              <p:nvPr/>
            </p:nvSpPr>
            <p:spPr>
              <a:xfrm>
                <a:off x="4875762" y="5081061"/>
                <a:ext cx="864565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 replica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文本框 269"/>
              <p:cNvSpPr txBox="1"/>
              <p:nvPr/>
            </p:nvSpPr>
            <p:spPr>
              <a:xfrm>
                <a:off x="4177227" y="5199437"/>
                <a:ext cx="157532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quinoline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lkaloid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文本框 270"/>
              <p:cNvSpPr txBox="1"/>
              <p:nvPr/>
            </p:nvSpPr>
            <p:spPr>
              <a:xfrm>
                <a:off x="4803568" y="5310761"/>
                <a:ext cx="943870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lfur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文本框 271"/>
              <p:cNvSpPr txBox="1"/>
              <p:nvPr/>
            </p:nvSpPr>
            <p:spPr>
              <a:xfrm>
                <a:off x="4705609" y="5421063"/>
                <a:ext cx="104438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trogen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文本框 272"/>
              <p:cNvSpPr txBox="1"/>
              <p:nvPr/>
            </p:nvSpPr>
            <p:spPr>
              <a:xfrm>
                <a:off x="4574798" y="5537191"/>
                <a:ext cx="118680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otenoid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文本框 273"/>
              <p:cNvSpPr txBox="1"/>
              <p:nvPr/>
            </p:nvSpPr>
            <p:spPr>
              <a:xfrm>
                <a:off x="4545726" y="5657004"/>
                <a:ext cx="121930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terpenoid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5" name="文本框 274"/>
              <p:cNvSpPr txBox="1"/>
              <p:nvPr/>
            </p:nvSpPr>
            <p:spPr>
              <a:xfrm>
                <a:off x="3671624" y="5777663"/>
                <a:ext cx="209440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ino sugar and nucleotide sugar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6" name="文本框 275"/>
              <p:cNvSpPr txBox="1"/>
              <p:nvPr/>
            </p:nvSpPr>
            <p:spPr>
              <a:xfrm>
                <a:off x="4498457" y="5887965"/>
                <a:ext cx="1260992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enylalani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7" name="文本框 276"/>
              <p:cNvSpPr txBox="1"/>
              <p:nvPr/>
            </p:nvSpPr>
            <p:spPr>
              <a:xfrm>
                <a:off x="4062364" y="6008325"/>
                <a:ext cx="1718782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steine and methioni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文本框 277"/>
              <p:cNvSpPr txBox="1"/>
              <p:nvPr/>
            </p:nvSpPr>
            <p:spPr>
              <a:xfrm>
                <a:off x="4205630" y="6118140"/>
                <a:ext cx="1575359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tosynthesis - antenna protein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文本框 278"/>
              <p:cNvSpPr txBox="1"/>
              <p:nvPr/>
            </p:nvSpPr>
            <p:spPr>
              <a:xfrm>
                <a:off x="4051904" y="6236009"/>
                <a:ext cx="1710350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tin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berine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d wax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80" name="矩形 279"/>
            <p:cNvSpPr/>
            <p:nvPr/>
          </p:nvSpPr>
          <p:spPr>
            <a:xfrm>
              <a:off x="6526" y="7179"/>
              <a:ext cx="2377" cy="20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281" name="组合 280"/>
            <p:cNvGrpSpPr/>
            <p:nvPr/>
          </p:nvGrpSpPr>
          <p:grpSpPr>
            <a:xfrm>
              <a:off x="5419" y="10526"/>
              <a:ext cx="5434" cy="4537"/>
              <a:chOff x="-59895" y="3967762"/>
              <a:chExt cx="3450400" cy="2881306"/>
            </a:xfrm>
          </p:grpSpPr>
          <p:pic>
            <p:nvPicPr>
              <p:cNvPr id="282" name="图片 28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160" t="3626" r="349" b="4581"/>
              <a:stretch>
                <a:fillRect/>
              </a:stretch>
            </p:blipFill>
            <p:spPr>
              <a:xfrm>
                <a:off x="2037140" y="4202011"/>
                <a:ext cx="1170347" cy="2360713"/>
              </a:xfrm>
              <a:prstGeom prst="rect">
                <a:avLst/>
              </a:prstGeom>
            </p:spPr>
          </p:pic>
          <p:sp>
            <p:nvSpPr>
              <p:cNvPr id="283" name="文本框 282"/>
              <p:cNvSpPr txBox="1"/>
              <p:nvPr/>
            </p:nvSpPr>
            <p:spPr>
              <a:xfrm>
                <a:off x="1021308" y="4157772"/>
                <a:ext cx="1112696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3 signaling pathwa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文本框 283"/>
              <p:cNvSpPr txBox="1"/>
              <p:nvPr/>
            </p:nvSpPr>
            <p:spPr>
              <a:xfrm>
                <a:off x="1317284" y="4279466"/>
                <a:ext cx="80496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iosis - yeas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文本框 284"/>
              <p:cNvSpPr txBox="1"/>
              <p:nvPr/>
            </p:nvSpPr>
            <p:spPr>
              <a:xfrm>
                <a:off x="1238480" y="4387188"/>
                <a:ext cx="888346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cycle - yeas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文本框 285"/>
              <p:cNvSpPr txBox="1"/>
              <p:nvPr/>
            </p:nvSpPr>
            <p:spPr>
              <a:xfrm>
                <a:off x="1530235" y="4508882"/>
                <a:ext cx="61284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cycl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7" name="文本框 286"/>
              <p:cNvSpPr txBox="1"/>
              <p:nvPr/>
            </p:nvSpPr>
            <p:spPr>
              <a:xfrm>
                <a:off x="950875" y="4622578"/>
                <a:ext cx="1183129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xO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ignaling pathwa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8" name="文本框 287"/>
              <p:cNvSpPr txBox="1"/>
              <p:nvPr/>
            </p:nvSpPr>
            <p:spPr>
              <a:xfrm>
                <a:off x="934162" y="4730300"/>
                <a:ext cx="1205076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nconi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emia pathway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9" name="文本框 288"/>
              <p:cNvSpPr txBox="1"/>
              <p:nvPr/>
            </p:nvSpPr>
            <p:spPr>
              <a:xfrm>
                <a:off x="1273119" y="4850019"/>
                <a:ext cx="868041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 replicatio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0" name="文本框 289"/>
              <p:cNvSpPr txBox="1"/>
              <p:nvPr/>
            </p:nvSpPr>
            <p:spPr>
              <a:xfrm>
                <a:off x="459664" y="4969738"/>
                <a:ext cx="1715239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gradation of aromatic compound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1" name="文本框 290"/>
              <p:cNvSpPr txBox="1"/>
              <p:nvPr/>
            </p:nvSpPr>
            <p:spPr>
              <a:xfrm>
                <a:off x="1133085" y="5085507"/>
                <a:ext cx="983407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bon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2" name="文本框 291"/>
              <p:cNvSpPr txBox="1"/>
              <p:nvPr/>
            </p:nvSpPr>
            <p:spPr>
              <a:xfrm>
                <a:off x="-59895" y="5205226"/>
                <a:ext cx="2221617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ilbenoid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arylheptanoid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ingerol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3" name="文本框 292"/>
              <p:cNvSpPr txBox="1"/>
              <p:nvPr/>
            </p:nvSpPr>
            <p:spPr>
              <a:xfrm>
                <a:off x="986099" y="5311349"/>
                <a:ext cx="1134767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vonoid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4" name="文本框 293"/>
              <p:cNvSpPr txBox="1"/>
              <p:nvPr/>
            </p:nvSpPr>
            <p:spPr>
              <a:xfrm>
                <a:off x="697630" y="5417472"/>
                <a:ext cx="140673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enylpropanoid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iosynthesi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5" name="文本框 294"/>
              <p:cNvSpPr txBox="1"/>
              <p:nvPr/>
            </p:nvSpPr>
            <p:spPr>
              <a:xfrm>
                <a:off x="1179391" y="5537191"/>
                <a:ext cx="948535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lfur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6" name="文本框 295"/>
              <p:cNvSpPr txBox="1"/>
              <p:nvPr/>
            </p:nvSpPr>
            <p:spPr>
              <a:xfrm>
                <a:off x="125922" y="5666447"/>
                <a:ext cx="204889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rbon fixation in photosynthetic organism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7" name="文本框 296"/>
              <p:cNvSpPr txBox="1"/>
              <p:nvPr/>
            </p:nvSpPr>
            <p:spPr>
              <a:xfrm>
                <a:off x="953846" y="5770971"/>
                <a:ext cx="1170280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utathio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8" name="文本框 297"/>
              <p:cNvSpPr txBox="1"/>
              <p:nvPr/>
            </p:nvSpPr>
            <p:spPr>
              <a:xfrm>
                <a:off x="853410" y="5880767"/>
                <a:ext cx="1261381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enylalani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9" name="文本框 298"/>
              <p:cNvSpPr txBox="1"/>
              <p:nvPr/>
            </p:nvSpPr>
            <p:spPr>
              <a:xfrm>
                <a:off x="593115" y="6004227"/>
                <a:ext cx="1568607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ginine and </a:t>
                </a:r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line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0" name="文本框 299"/>
              <p:cNvSpPr txBox="1"/>
              <p:nvPr/>
            </p:nvSpPr>
            <p:spPr>
              <a:xfrm>
                <a:off x="432416" y="6110825"/>
                <a:ext cx="1711132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steine and methioni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1" name="文本框 300"/>
              <p:cNvSpPr txBox="1"/>
              <p:nvPr/>
            </p:nvSpPr>
            <p:spPr>
              <a:xfrm>
                <a:off x="979626" y="6226826"/>
                <a:ext cx="1147711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yrimidine metabolism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2" name="文本框 301"/>
              <p:cNvSpPr txBox="1"/>
              <p:nvPr/>
            </p:nvSpPr>
            <p:spPr>
              <a:xfrm>
                <a:off x="575185" y="6350973"/>
                <a:ext cx="1547063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hotosynthesis - antenna proteins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3" name="文本框 302"/>
              <p:cNvSpPr txBox="1"/>
              <p:nvPr/>
            </p:nvSpPr>
            <p:spPr>
              <a:xfrm>
                <a:off x="2122248" y="6635073"/>
                <a:ext cx="955694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richment Score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4" name="文本框 303"/>
              <p:cNvSpPr txBox="1"/>
              <p:nvPr/>
            </p:nvSpPr>
            <p:spPr>
              <a:xfrm>
                <a:off x="2033928" y="6518343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5" name="文本框 304"/>
              <p:cNvSpPr txBox="1"/>
              <p:nvPr/>
            </p:nvSpPr>
            <p:spPr>
              <a:xfrm>
                <a:off x="2291156" y="6518343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6" name="文本框 305"/>
              <p:cNvSpPr txBox="1"/>
              <p:nvPr/>
            </p:nvSpPr>
            <p:spPr>
              <a:xfrm>
                <a:off x="2552505" y="6518343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7" name="文本框 306"/>
              <p:cNvSpPr txBox="1"/>
              <p:nvPr/>
            </p:nvSpPr>
            <p:spPr>
              <a:xfrm>
                <a:off x="2814198" y="6518191"/>
                <a:ext cx="229438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8" name="文本框 307"/>
              <p:cNvSpPr txBox="1"/>
              <p:nvPr/>
            </p:nvSpPr>
            <p:spPr>
              <a:xfrm>
                <a:off x="1207114" y="3967762"/>
                <a:ext cx="2183391" cy="213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-TMV VS SL(total):KEGG enrichment top 20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09" name="文本框 308"/>
            <p:cNvSpPr txBox="1"/>
            <p:nvPr/>
          </p:nvSpPr>
          <p:spPr>
            <a:xfrm>
              <a:off x="6028" y="10680"/>
              <a:ext cx="420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Times New Roman" panose="02020603050405020304" pitchFamily="18" charset="0"/>
                  <a:cs typeface="Times New Roman" panose="02020603050405020304" pitchFamily="18" charset="0"/>
                </a:rPr>
                <a:t>f.</a:t>
              </a:r>
            </a:p>
          </p:txBody>
        </p:sp>
        <p:pic>
          <p:nvPicPr>
            <p:cNvPr id="71" name="图片 7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412" t="34042" r="5393" b="54174"/>
            <a:stretch>
              <a:fillRect/>
            </a:stretch>
          </p:blipFill>
          <p:spPr>
            <a:xfrm>
              <a:off x="10182" y="2109"/>
              <a:ext cx="109" cy="472"/>
            </a:xfrm>
            <a:prstGeom prst="rect">
              <a:avLst/>
            </a:prstGeom>
          </p:spPr>
        </p:pic>
        <p:sp>
          <p:nvSpPr>
            <p:cNvPr id="138" name="文本框 137"/>
            <p:cNvSpPr txBox="1"/>
            <p:nvPr/>
          </p:nvSpPr>
          <p:spPr>
            <a:xfrm>
              <a:off x="9945" y="1719"/>
              <a:ext cx="1155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Number</a:t>
              </a: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10267" y="1968"/>
              <a:ext cx="51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5</a:t>
              </a:r>
            </a:p>
          </p:txBody>
        </p:sp>
        <p:sp>
          <p:nvSpPr>
            <p:cNvPr id="210" name="文本框 209"/>
            <p:cNvSpPr txBox="1"/>
            <p:nvPr/>
          </p:nvSpPr>
          <p:spPr>
            <a:xfrm>
              <a:off x="10277" y="2118"/>
              <a:ext cx="51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10</a:t>
              </a: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10281" y="2242"/>
              <a:ext cx="51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15</a:t>
              </a:r>
            </a:p>
          </p:txBody>
        </p:sp>
        <p:sp>
          <p:nvSpPr>
            <p:cNvPr id="213" name="文本框 212"/>
            <p:cNvSpPr txBox="1"/>
            <p:nvPr/>
          </p:nvSpPr>
          <p:spPr>
            <a:xfrm>
              <a:off x="10287" y="2378"/>
              <a:ext cx="512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20</a:t>
              </a:r>
            </a:p>
          </p:txBody>
        </p:sp>
        <p:pic>
          <p:nvPicPr>
            <p:cNvPr id="310" name="图片 30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178" t="52018" r="5393" b="32053"/>
            <a:stretch>
              <a:fillRect/>
            </a:stretch>
          </p:blipFill>
          <p:spPr>
            <a:xfrm>
              <a:off x="10127" y="3554"/>
              <a:ext cx="117" cy="638"/>
            </a:xfrm>
            <a:prstGeom prst="rect">
              <a:avLst/>
            </a:prstGeom>
          </p:spPr>
        </p:pic>
        <p:sp>
          <p:nvSpPr>
            <p:cNvPr id="311" name="文本框 310"/>
            <p:cNvSpPr txBox="1"/>
            <p:nvPr/>
          </p:nvSpPr>
          <p:spPr>
            <a:xfrm>
              <a:off x="10021" y="3109"/>
              <a:ext cx="1003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p-value</a:t>
              </a:r>
            </a:p>
          </p:txBody>
        </p:sp>
        <p:sp>
          <p:nvSpPr>
            <p:cNvPr id="312" name="文本框 311"/>
            <p:cNvSpPr txBox="1"/>
            <p:nvPr/>
          </p:nvSpPr>
          <p:spPr>
            <a:xfrm>
              <a:off x="10124" y="3426"/>
              <a:ext cx="103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0.020</a:t>
              </a:r>
            </a:p>
          </p:txBody>
        </p:sp>
        <p:sp>
          <p:nvSpPr>
            <p:cNvPr id="313" name="文本框 312"/>
            <p:cNvSpPr txBox="1"/>
            <p:nvPr/>
          </p:nvSpPr>
          <p:spPr>
            <a:xfrm>
              <a:off x="10124" y="3612"/>
              <a:ext cx="103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0.015</a:t>
              </a:r>
            </a:p>
          </p:txBody>
        </p:sp>
        <p:sp>
          <p:nvSpPr>
            <p:cNvPr id="314" name="文本框 313"/>
            <p:cNvSpPr txBox="1"/>
            <p:nvPr/>
          </p:nvSpPr>
          <p:spPr>
            <a:xfrm>
              <a:off x="10124" y="3773"/>
              <a:ext cx="103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0.010</a:t>
              </a:r>
            </a:p>
          </p:txBody>
        </p:sp>
        <p:sp>
          <p:nvSpPr>
            <p:cNvPr id="315" name="文本框 314"/>
            <p:cNvSpPr txBox="1"/>
            <p:nvPr/>
          </p:nvSpPr>
          <p:spPr>
            <a:xfrm>
              <a:off x="10124" y="3926"/>
              <a:ext cx="103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>
                  <a:latin typeface="Palatino Linotype" panose="02040502050505030304" charset="0"/>
                  <a:cs typeface="Palatino Linotype" panose="02040502050505030304" charset="0"/>
                </a:rPr>
                <a:t>0.005</a:t>
              </a:r>
            </a:p>
          </p:txBody>
        </p:sp>
      </p:grpSp>
      <p:sp>
        <p:nvSpPr>
          <p:cNvPr id="220" name="文本框 219"/>
          <p:cNvSpPr txBox="1"/>
          <p:nvPr/>
        </p:nvSpPr>
        <p:spPr>
          <a:xfrm>
            <a:off x="255149" y="10145330"/>
            <a:ext cx="6299436" cy="1014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GO and KEGG analysis of DEGs in different comparison groups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icotiana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.(a,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L vs CK, (c,d), SL-TMV vs TMV, (e,f), SL-TMV vs SL. Each figure showed top 20 pathways with Q values. CK, Healthy control without TMV inoculation or SL pretreatment; SL, Healthy control with SL pretreatment; TMV, TMV inoculation without SL pretreatment; SL-TMV, TMV inoculation with SL pretreatment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文本框 25"/>
          <p:cNvSpPr txBox="1"/>
          <p:nvPr/>
        </p:nvSpPr>
        <p:spPr>
          <a:xfrm>
            <a:off x="1149350" y="6880860"/>
            <a:ext cx="4482465" cy="553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Palatino Linotype" panose="02040502050505030304" charset="0"/>
                <a:cs typeface="Palatino Linotype" panose="02040502050505030304" charset="0"/>
                <a:sym typeface="+mn-ea"/>
              </a:rPr>
              <a:t> </a:t>
            </a:r>
            <a:r>
              <a:rPr lang="en-US" altLang="zh-CN" sz="1000">
                <a:latin typeface="Palatino Linotype" panose="02040502050505030304" charset="0"/>
                <a:cs typeface="Palatino Linotype" panose="02040502050505030304" charset="0"/>
                <a:sym typeface="+mn-ea"/>
              </a:rPr>
              <a:t>supplemental Figure S2</a:t>
            </a:r>
            <a:r>
              <a:rPr lang="en-US" altLang="zh-CN" sz="1000" dirty="0">
                <a:latin typeface="Palatino Linotype" panose="02040502050505030304" charset="0"/>
                <a:cs typeface="Palatino Linotype" panose="02040502050505030304" charset="0"/>
                <a:sym typeface="+mn-ea"/>
              </a:rPr>
              <a:t>. Expression of mRNAs by </a:t>
            </a:r>
            <a:r>
              <a:rPr lang="en-US" altLang="zh-CN" sz="1000" dirty="0" err="1">
                <a:latin typeface="Palatino Linotype" panose="02040502050505030304" charset="0"/>
                <a:cs typeface="Palatino Linotype" panose="02040502050505030304" charset="0"/>
                <a:sym typeface="+mn-ea"/>
              </a:rPr>
              <a:t>qRT</a:t>
            </a:r>
            <a:r>
              <a:rPr lang="en-US" altLang="zh-CN" sz="1000" dirty="0">
                <a:latin typeface="Palatino Linotype" panose="02040502050505030304" charset="0"/>
                <a:cs typeface="Palatino Linotype" panose="02040502050505030304" charset="0"/>
                <a:sym typeface="+mn-ea"/>
              </a:rPr>
              <a:t>-PCR. Values represent the mean and ± SE of at least n = 3 biological replicates from two independent experiments </a:t>
            </a:r>
            <a:endParaRPr lang="zh-CN" altLang="en-US" sz="1000" dirty="0">
              <a:latin typeface="Palatino Linotype" panose="02040502050505030304" charset="0"/>
              <a:cs typeface="Palatino Linotype" panose="02040502050505030304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756920" y="1688465"/>
            <a:ext cx="5115560" cy="4925060"/>
            <a:chOff x="1192" y="2659"/>
            <a:chExt cx="8056" cy="7756"/>
          </a:xfrm>
        </p:grpSpPr>
        <p:pic>
          <p:nvPicPr>
            <p:cNvPr id="2" name="图片 1" descr="数据 1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3"/>
            <a:stretch>
              <a:fillRect/>
            </a:stretch>
          </p:blipFill>
          <p:spPr>
            <a:xfrm>
              <a:off x="1509" y="2781"/>
              <a:ext cx="3712" cy="3377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2155" y="577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CK</a:t>
              </a:r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2664" y="5772"/>
              <a:ext cx="7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TMV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384" y="578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3794" y="5782"/>
              <a:ext cx="11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-TMV</a:t>
              </a:r>
            </a:p>
          </p:txBody>
        </p:sp>
        <p:sp>
          <p:nvSpPr>
            <p:cNvPr id="241" name="文本框 240"/>
            <p:cNvSpPr txBox="1"/>
            <p:nvPr/>
          </p:nvSpPr>
          <p:spPr>
            <a:xfrm rot="10800000">
              <a:off x="1192" y="3267"/>
              <a:ext cx="506" cy="201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>
                  <a:latin typeface="Palatino Linotype" panose="02040502050505030304" charset="0"/>
                  <a:cs typeface="Palatino Linotype" panose="02040502050505030304" charset="0"/>
                </a:rPr>
                <a:t>Relative expression</a:t>
              </a:r>
            </a:p>
          </p:txBody>
        </p:sp>
        <p:pic>
          <p:nvPicPr>
            <p:cNvPr id="7" name="图片 6" descr="数据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83" y="2659"/>
              <a:ext cx="3586" cy="3322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5875" y="552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CK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6384" y="5522"/>
              <a:ext cx="7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TMV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104" y="553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7514" y="5532"/>
              <a:ext cx="11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-TMV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 rot="10800000">
              <a:off x="5052" y="3237"/>
              <a:ext cx="506" cy="201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>
                  <a:latin typeface="Palatino Linotype" panose="02040502050505030304" charset="0"/>
                  <a:cs typeface="Palatino Linotype" panose="02040502050505030304" charset="0"/>
                </a:rPr>
                <a:t>Relative expression</a:t>
              </a:r>
            </a:p>
          </p:txBody>
        </p:sp>
        <p:pic>
          <p:nvPicPr>
            <p:cNvPr id="13" name="图片 12" descr="数据 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58" y="6865"/>
              <a:ext cx="3820" cy="3551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2135" y="987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CK</a:t>
              </a: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644" y="9872"/>
              <a:ext cx="7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TMV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364" y="988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774" y="9882"/>
              <a:ext cx="11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-TMV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 rot="10800000">
              <a:off x="1192" y="7305"/>
              <a:ext cx="506" cy="201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>
                  <a:latin typeface="Palatino Linotype" panose="02040502050505030304" charset="0"/>
                  <a:cs typeface="Palatino Linotype" panose="02040502050505030304" charset="0"/>
                </a:rPr>
                <a:t>Relative expression</a:t>
              </a:r>
            </a:p>
          </p:txBody>
        </p:sp>
        <p:pic>
          <p:nvPicPr>
            <p:cNvPr id="20" name="图片 19" descr="数据 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58" y="6985"/>
              <a:ext cx="3691" cy="3431"/>
            </a:xfrm>
            <a:prstGeom prst="rect">
              <a:avLst/>
            </a:prstGeom>
          </p:spPr>
        </p:pic>
        <p:sp>
          <p:nvSpPr>
            <p:cNvPr id="21" name="文本框 20"/>
            <p:cNvSpPr txBox="1"/>
            <p:nvPr/>
          </p:nvSpPr>
          <p:spPr>
            <a:xfrm rot="10800000">
              <a:off x="5278" y="7492"/>
              <a:ext cx="506" cy="201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dirty="0">
                  <a:latin typeface="Palatino Linotype" panose="02040502050505030304" charset="0"/>
                  <a:cs typeface="Palatino Linotype" panose="02040502050505030304" charset="0"/>
                </a:rPr>
                <a:t>Relative expression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6235" y="990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CK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6744" y="9902"/>
              <a:ext cx="75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TMV</a:t>
              </a: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7464" y="9912"/>
              <a:ext cx="65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7874" y="9912"/>
              <a:ext cx="1120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Palatino Linotype" panose="02040502050505030304" charset="0"/>
                  <a:cs typeface="Palatino Linotype" panose="02040502050505030304" charset="0"/>
                </a:rPr>
                <a:t>SL-TMV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664" y="3014"/>
              <a:ext cx="1706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>
                  <a:latin typeface="Palatino Linotype" panose="02040502050505030304" charset="0"/>
                  <a:cs typeface="Palatino Linotype" panose="02040502050505030304" charset="0"/>
                </a:rPr>
                <a:t>NtERF1</a:t>
              </a: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6484" y="2929"/>
              <a:ext cx="1706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>
                  <a:latin typeface="Palatino Linotype" panose="02040502050505030304" charset="0"/>
                  <a:cs typeface="Palatino Linotype" panose="02040502050505030304" charset="0"/>
                </a:rPr>
                <a:t>NtEIN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2512" y="7106"/>
              <a:ext cx="1706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>
                  <a:latin typeface="Palatino Linotype" panose="02040502050505030304" charset="0"/>
                  <a:cs typeface="Palatino Linotype" panose="02040502050505030304" charset="0"/>
                </a:rPr>
                <a:t>NtABF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6409" y="7305"/>
              <a:ext cx="1706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>
                  <a:latin typeface="Palatino Linotype" panose="02040502050505030304" charset="0"/>
                  <a:cs typeface="Palatino Linotype" panose="02040502050505030304" charset="0"/>
                </a:rPr>
                <a:t>NtPYL2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Dk1YWQ2NWFkMDQ1MDFmMzc0MjJjN2Y3NGQwMjJhYjYifQ=="/>
  <p:tag name="KSO_WPP_MARK_KEY" val="51e4d5a4-6047-4ce2-979e-cd0bc7f9b966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3866,&quot;width&quot;:4250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9</Words>
  <Application>Microsoft Office PowerPoint</Application>
  <PresentationFormat>Widescreen</PresentationFormat>
  <Paragraphs>2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Palatino Linotype</vt:lpstr>
      <vt:lpstr>Times New Roman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黄仁艳</dc:creator>
  <cp:lastModifiedBy>MDPI</cp:lastModifiedBy>
  <cp:revision>24</cp:revision>
  <dcterms:created xsi:type="dcterms:W3CDTF">2024-07-15T03:11:00Z</dcterms:created>
  <dcterms:modified xsi:type="dcterms:W3CDTF">2024-08-04T10:3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D8FCF2262354B03B52874830F4531A1</vt:lpwstr>
  </property>
  <property fmtid="{D5CDD505-2E9C-101B-9397-08002B2CF9AE}" pid="3" name="KSOProductBuildVer">
    <vt:lpwstr>2052-11.1.0.12165</vt:lpwstr>
  </property>
</Properties>
</file>